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C754AFD-733E-4F0A-A56C-4CCF838AEA10}" v="27" dt="2023-07-19T13:25:56.21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30" autoAdjust="0"/>
    <p:restoredTop sz="94660"/>
  </p:normalViewPr>
  <p:slideViewPr>
    <p:cSldViewPr snapToGrid="0">
      <p:cViewPr>
        <p:scale>
          <a:sx n="75" d="100"/>
          <a:sy n="75" d="100"/>
        </p:scale>
        <p:origin x="822" y="-9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AN MANUEL LOZANO GIL" userId="618ed11e-cb2c-4b03-8ac9-a8cf52f924c9" providerId="ADAL" clId="{2C754AFD-733E-4F0A-A56C-4CCF838AEA10}"/>
    <pc:docChg chg="custSel delSld modSld">
      <pc:chgData name="JUAN MANUEL LOZANO GIL" userId="618ed11e-cb2c-4b03-8ac9-a8cf52f924c9" providerId="ADAL" clId="{2C754AFD-733E-4F0A-A56C-4CCF838AEA10}" dt="2023-07-19T13:26:29.631" v="379" actId="21"/>
      <pc:docMkLst>
        <pc:docMk/>
      </pc:docMkLst>
      <pc:sldChg chg="del">
        <pc:chgData name="JUAN MANUEL LOZANO GIL" userId="618ed11e-cb2c-4b03-8ac9-a8cf52f924c9" providerId="ADAL" clId="{2C754AFD-733E-4F0A-A56C-4CCF838AEA10}" dt="2023-07-19T12:16:27.661" v="2" actId="47"/>
        <pc:sldMkLst>
          <pc:docMk/>
          <pc:sldMk cId="1035658693" sldId="256"/>
        </pc:sldMkLst>
      </pc:sldChg>
      <pc:sldChg chg="addSp delSp modSp mod">
        <pc:chgData name="JUAN MANUEL LOZANO GIL" userId="618ed11e-cb2c-4b03-8ac9-a8cf52f924c9" providerId="ADAL" clId="{2C754AFD-733E-4F0A-A56C-4CCF838AEA10}" dt="2023-07-19T13:26:29.631" v="379" actId="21"/>
        <pc:sldMkLst>
          <pc:docMk/>
          <pc:sldMk cId="236126241" sldId="257"/>
        </pc:sldMkLst>
        <pc:spChg chg="mod">
          <ac:chgData name="JUAN MANUEL LOZANO GIL" userId="618ed11e-cb2c-4b03-8ac9-a8cf52f924c9" providerId="ADAL" clId="{2C754AFD-733E-4F0A-A56C-4CCF838AEA10}" dt="2023-07-19T12:24:12.958" v="207" actId="1036"/>
          <ac:spMkLst>
            <pc:docMk/>
            <pc:sldMk cId="236126241" sldId="257"/>
            <ac:spMk id="16" creationId="{004BF03E-1D72-3441-66DB-949991E03FD6}"/>
          </ac:spMkLst>
        </pc:spChg>
        <pc:spChg chg="mod">
          <ac:chgData name="JUAN MANUEL LOZANO GIL" userId="618ed11e-cb2c-4b03-8ac9-a8cf52f924c9" providerId="ADAL" clId="{2C754AFD-733E-4F0A-A56C-4CCF838AEA10}" dt="2023-07-19T12:18:03.182" v="35" actId="1076"/>
          <ac:spMkLst>
            <pc:docMk/>
            <pc:sldMk cId="236126241" sldId="257"/>
            <ac:spMk id="18" creationId="{61D6E092-9B1B-66F5-E077-9BEB59D9A1C9}"/>
          </ac:spMkLst>
        </pc:spChg>
        <pc:spChg chg="mod">
          <ac:chgData name="JUAN MANUEL LOZANO GIL" userId="618ed11e-cb2c-4b03-8ac9-a8cf52f924c9" providerId="ADAL" clId="{2C754AFD-733E-4F0A-A56C-4CCF838AEA10}" dt="2023-07-19T12:18:07.814" v="37" actId="1076"/>
          <ac:spMkLst>
            <pc:docMk/>
            <pc:sldMk cId="236126241" sldId="257"/>
            <ac:spMk id="23" creationId="{BB07BF14-FBBC-39F2-C4C8-BD48E3FD1C37}"/>
          </ac:spMkLst>
        </pc:spChg>
        <pc:spChg chg="mod">
          <ac:chgData name="JUAN MANUEL LOZANO GIL" userId="618ed11e-cb2c-4b03-8ac9-a8cf52f924c9" providerId="ADAL" clId="{2C754AFD-733E-4F0A-A56C-4CCF838AEA10}" dt="2023-07-19T12:18:13.310" v="38" actId="1076"/>
          <ac:spMkLst>
            <pc:docMk/>
            <pc:sldMk cId="236126241" sldId="257"/>
            <ac:spMk id="25" creationId="{1C53B108-3DE7-4A98-D5C7-5CB2540F6AF5}"/>
          </ac:spMkLst>
        </pc:spChg>
        <pc:spChg chg="del mod">
          <ac:chgData name="JUAN MANUEL LOZANO GIL" userId="618ed11e-cb2c-4b03-8ac9-a8cf52f924c9" providerId="ADAL" clId="{2C754AFD-733E-4F0A-A56C-4CCF838AEA10}" dt="2023-07-19T12:17:52.967" v="33" actId="478"/>
          <ac:spMkLst>
            <pc:docMk/>
            <pc:sldMk cId="236126241" sldId="257"/>
            <ac:spMk id="28" creationId="{8ECA5BE9-CEF0-86BD-F518-332E43228C31}"/>
          </ac:spMkLst>
        </pc:spChg>
        <pc:spChg chg="mod">
          <ac:chgData name="JUAN MANUEL LOZANO GIL" userId="618ed11e-cb2c-4b03-8ac9-a8cf52f924c9" providerId="ADAL" clId="{2C754AFD-733E-4F0A-A56C-4CCF838AEA10}" dt="2023-07-19T12:27:02.029" v="236" actId="1076"/>
          <ac:spMkLst>
            <pc:docMk/>
            <pc:sldMk cId="236126241" sldId="257"/>
            <ac:spMk id="29" creationId="{2135E244-1F3B-7BF0-3F61-E9745CC66162}"/>
          </ac:spMkLst>
        </pc:spChg>
        <pc:spChg chg="mod ord">
          <ac:chgData name="JUAN MANUEL LOZANO GIL" userId="618ed11e-cb2c-4b03-8ac9-a8cf52f924c9" providerId="ADAL" clId="{2C754AFD-733E-4F0A-A56C-4CCF838AEA10}" dt="2023-07-19T12:27:02.029" v="236" actId="1076"/>
          <ac:spMkLst>
            <pc:docMk/>
            <pc:sldMk cId="236126241" sldId="257"/>
            <ac:spMk id="30" creationId="{E74161A8-0EA0-0E29-6DB3-12E4B8BA11B5}"/>
          </ac:spMkLst>
        </pc:spChg>
        <pc:spChg chg="del">
          <ac:chgData name="JUAN MANUEL LOZANO GIL" userId="618ed11e-cb2c-4b03-8ac9-a8cf52f924c9" providerId="ADAL" clId="{2C754AFD-733E-4F0A-A56C-4CCF838AEA10}" dt="2023-07-19T12:16:24.606" v="1" actId="478"/>
          <ac:spMkLst>
            <pc:docMk/>
            <pc:sldMk cId="236126241" sldId="257"/>
            <ac:spMk id="31" creationId="{84D3EA54-4A00-DE9C-7E19-0C088717B835}"/>
          </ac:spMkLst>
        </pc:spChg>
        <pc:spChg chg="del">
          <ac:chgData name="JUAN MANUEL LOZANO GIL" userId="618ed11e-cb2c-4b03-8ac9-a8cf52f924c9" providerId="ADAL" clId="{2C754AFD-733E-4F0A-A56C-4CCF838AEA10}" dt="2023-07-19T12:16:24.606" v="1" actId="478"/>
          <ac:spMkLst>
            <pc:docMk/>
            <pc:sldMk cId="236126241" sldId="257"/>
            <ac:spMk id="32" creationId="{935DF1CE-9C86-BAEA-FCBC-116924EE940B}"/>
          </ac:spMkLst>
        </pc:spChg>
        <pc:spChg chg="del mod">
          <ac:chgData name="JUAN MANUEL LOZANO GIL" userId="618ed11e-cb2c-4b03-8ac9-a8cf52f924c9" providerId="ADAL" clId="{2C754AFD-733E-4F0A-A56C-4CCF838AEA10}" dt="2023-07-19T12:17:50.407" v="32" actId="478"/>
          <ac:spMkLst>
            <pc:docMk/>
            <pc:sldMk cId="236126241" sldId="257"/>
            <ac:spMk id="34" creationId="{247046FE-DF86-CF08-1D4A-3D48398249ED}"/>
          </ac:spMkLst>
        </pc:spChg>
        <pc:spChg chg="del mod">
          <ac:chgData name="JUAN MANUEL LOZANO GIL" userId="618ed11e-cb2c-4b03-8ac9-a8cf52f924c9" providerId="ADAL" clId="{2C754AFD-733E-4F0A-A56C-4CCF838AEA10}" dt="2023-07-19T12:17:45.390" v="29" actId="478"/>
          <ac:spMkLst>
            <pc:docMk/>
            <pc:sldMk cId="236126241" sldId="257"/>
            <ac:spMk id="35" creationId="{AB8EAAEB-222C-D1F1-5888-8D9933713971}"/>
          </ac:spMkLst>
        </pc:spChg>
        <pc:spChg chg="del mod">
          <ac:chgData name="JUAN MANUEL LOZANO GIL" userId="618ed11e-cb2c-4b03-8ac9-a8cf52f924c9" providerId="ADAL" clId="{2C754AFD-733E-4F0A-A56C-4CCF838AEA10}" dt="2023-07-19T12:17:43.790" v="28" actId="478"/>
          <ac:spMkLst>
            <pc:docMk/>
            <pc:sldMk cId="236126241" sldId="257"/>
            <ac:spMk id="36" creationId="{24BED31E-8D2C-BF85-2EE5-9B0A3B1A4C8E}"/>
          </ac:spMkLst>
        </pc:spChg>
        <pc:spChg chg="add mod">
          <ac:chgData name="JUAN MANUEL LOZANO GIL" userId="618ed11e-cb2c-4b03-8ac9-a8cf52f924c9" providerId="ADAL" clId="{2C754AFD-733E-4F0A-A56C-4CCF838AEA10}" dt="2023-07-19T12:27:02.029" v="236" actId="1076"/>
          <ac:spMkLst>
            <pc:docMk/>
            <pc:sldMk cId="236126241" sldId="257"/>
            <ac:spMk id="44" creationId="{E7F871D1-DD2C-1CDC-89C0-9E1267696010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45" creationId="{98AE03D9-FDF9-A915-BF73-D611CF569C40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46" creationId="{58B01AA3-91AC-F63F-F050-653F649E7EA1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47" creationId="{4B22347D-0C44-ECC2-4A87-5A947201C2B5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48" creationId="{4646C71E-F31D-136E-1727-1EE0F1C6FDD0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49" creationId="{93A62BB7-F385-F9A6-002D-A1A15CD2E919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50" creationId="{142547B8-3FED-FBBB-A1C1-B24ECB545C35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51" creationId="{2AE99E3E-5EA5-28B4-990D-C6FE82C6D11A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52" creationId="{71EE4F11-A1E8-6C82-6CA4-0D2C993E6536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53" creationId="{51F8C930-0D7A-9854-EF3B-6B87716D26BA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54" creationId="{54E3A0E3-A904-3548-6384-7A687C9BCA42}"/>
          </ac:spMkLst>
        </pc:spChg>
        <pc:spChg chg="add mod">
          <ac:chgData name="JUAN MANUEL LOZANO GIL" userId="618ed11e-cb2c-4b03-8ac9-a8cf52f924c9" providerId="ADAL" clId="{2C754AFD-733E-4F0A-A56C-4CCF838AEA10}" dt="2023-07-19T12:27:02.029" v="236" actId="1076"/>
          <ac:spMkLst>
            <pc:docMk/>
            <pc:sldMk cId="236126241" sldId="257"/>
            <ac:spMk id="58" creationId="{43A1FED4-B30E-3905-0EF1-17DA44FC7FB8}"/>
          </ac:spMkLst>
        </pc:spChg>
        <pc:spChg chg="add mod">
          <ac:chgData name="JUAN MANUEL LOZANO GIL" userId="618ed11e-cb2c-4b03-8ac9-a8cf52f924c9" providerId="ADAL" clId="{2C754AFD-733E-4F0A-A56C-4CCF838AEA10}" dt="2023-07-19T12:27:02.029" v="236" actId="1076"/>
          <ac:spMkLst>
            <pc:docMk/>
            <pc:sldMk cId="236126241" sldId="257"/>
            <ac:spMk id="59" creationId="{A473DF37-5308-B1AF-C511-0D15B7EE8B94}"/>
          </ac:spMkLst>
        </pc:spChg>
        <pc:spChg chg="add del mod">
          <ac:chgData name="JUAN MANUEL LOZANO GIL" userId="618ed11e-cb2c-4b03-8ac9-a8cf52f924c9" providerId="ADAL" clId="{2C754AFD-733E-4F0A-A56C-4CCF838AEA10}" dt="2023-07-19T12:22:48.502" v="87" actId="478"/>
          <ac:spMkLst>
            <pc:docMk/>
            <pc:sldMk cId="236126241" sldId="257"/>
            <ac:spMk id="60" creationId="{8305FE67-9F02-2733-51BE-A57F93CAB82E}"/>
          </ac:spMkLst>
        </pc:spChg>
        <pc:spChg chg="mod">
          <ac:chgData name="JUAN MANUEL LOZANO GIL" userId="618ed11e-cb2c-4b03-8ac9-a8cf52f924c9" providerId="ADAL" clId="{2C754AFD-733E-4F0A-A56C-4CCF838AEA10}" dt="2023-07-19T12:23:31.599" v="102" actId="1035"/>
          <ac:spMkLst>
            <pc:docMk/>
            <pc:sldMk cId="236126241" sldId="257"/>
            <ac:spMk id="65" creationId="{264484C2-2B45-D946-F22F-2C34231B1762}"/>
          </ac:spMkLst>
        </pc:spChg>
        <pc:spChg chg="mod">
          <ac:chgData name="JUAN MANUEL LOZANO GIL" userId="618ed11e-cb2c-4b03-8ac9-a8cf52f924c9" providerId="ADAL" clId="{2C754AFD-733E-4F0A-A56C-4CCF838AEA10}" dt="2023-07-19T12:23:37.743" v="123" actId="1036"/>
          <ac:spMkLst>
            <pc:docMk/>
            <pc:sldMk cId="236126241" sldId="257"/>
            <ac:spMk id="66" creationId="{BD0FAB52-B17A-8882-61F6-79F727941CDD}"/>
          </ac:spMkLst>
        </pc:spChg>
        <pc:spChg chg="mod">
          <ac:chgData name="JUAN MANUEL LOZANO GIL" userId="618ed11e-cb2c-4b03-8ac9-a8cf52f924c9" providerId="ADAL" clId="{2C754AFD-733E-4F0A-A56C-4CCF838AEA10}" dt="2023-07-19T12:23:41.318" v="133" actId="1035"/>
          <ac:spMkLst>
            <pc:docMk/>
            <pc:sldMk cId="236126241" sldId="257"/>
            <ac:spMk id="67" creationId="{422FDD0B-58C7-4479-0D00-95C4EF43A919}"/>
          </ac:spMkLst>
        </pc:spChg>
        <pc:spChg chg="mod">
          <ac:chgData name="JUAN MANUEL LOZANO GIL" userId="618ed11e-cb2c-4b03-8ac9-a8cf52f924c9" providerId="ADAL" clId="{2C754AFD-733E-4F0A-A56C-4CCF838AEA10}" dt="2023-07-19T12:23:50.342" v="153" actId="1035"/>
          <ac:spMkLst>
            <pc:docMk/>
            <pc:sldMk cId="236126241" sldId="257"/>
            <ac:spMk id="68" creationId="{E95384B0-D4F4-3A37-E705-0174266AE06C}"/>
          </ac:spMkLst>
        </pc:spChg>
        <pc:spChg chg="mod">
          <ac:chgData name="JUAN MANUEL LOZANO GIL" userId="618ed11e-cb2c-4b03-8ac9-a8cf52f924c9" providerId="ADAL" clId="{2C754AFD-733E-4F0A-A56C-4CCF838AEA10}" dt="2023-07-19T12:24:34.847" v="214" actId="1035"/>
          <ac:spMkLst>
            <pc:docMk/>
            <pc:sldMk cId="236126241" sldId="257"/>
            <ac:spMk id="69" creationId="{AAC3DCE8-3FCF-C02C-D2CA-3AB16CC97201}"/>
          </ac:spMkLst>
        </pc:spChg>
        <pc:spChg chg="mod">
          <ac:chgData name="JUAN MANUEL LOZANO GIL" userId="618ed11e-cb2c-4b03-8ac9-a8cf52f924c9" providerId="ADAL" clId="{2C754AFD-733E-4F0A-A56C-4CCF838AEA10}" dt="2023-07-19T12:23:59.784" v="179" actId="1036"/>
          <ac:spMkLst>
            <pc:docMk/>
            <pc:sldMk cId="236126241" sldId="257"/>
            <ac:spMk id="70" creationId="{A6BEE17A-6AC2-1FFA-2986-9F214E1B461D}"/>
          </ac:spMkLst>
        </pc:spChg>
        <pc:spChg chg="mod">
          <ac:chgData name="JUAN MANUEL LOZANO GIL" userId="618ed11e-cb2c-4b03-8ac9-a8cf52f924c9" providerId="ADAL" clId="{2C754AFD-733E-4F0A-A56C-4CCF838AEA10}" dt="2023-07-19T12:24:04.486" v="189" actId="1036"/>
          <ac:spMkLst>
            <pc:docMk/>
            <pc:sldMk cId="236126241" sldId="257"/>
            <ac:spMk id="71" creationId="{91FA0395-1622-D6EE-6203-A3EFA130F284}"/>
          </ac:spMkLst>
        </pc:spChg>
        <pc:spChg chg="add mod">
          <ac:chgData name="JUAN MANUEL LOZANO GIL" userId="618ed11e-cb2c-4b03-8ac9-a8cf52f924c9" providerId="ADAL" clId="{2C754AFD-733E-4F0A-A56C-4CCF838AEA10}" dt="2023-07-19T12:27:12.532" v="239" actId="1076"/>
          <ac:spMkLst>
            <pc:docMk/>
            <pc:sldMk cId="236126241" sldId="257"/>
            <ac:spMk id="79" creationId="{A9EBDE9A-BBBC-92B4-5028-2898417ACC40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1" creationId="{BF6AA894-E2FB-95AF-4F87-AE16A58A4970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2" creationId="{9BB808CB-8826-9D29-A760-FD8CC4C8C536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3" creationId="{19F6353B-6BC6-1E74-833C-8366F077556B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4" creationId="{6CBC606F-BBBF-C9D3-6B63-E0C9A252924F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5" creationId="{F95CB61D-B67F-C671-8EEC-C42DA5F9C48F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6" creationId="{06287408-6066-1D4F-C1CB-FE893812E6B4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7" creationId="{47D65355-B992-99AC-CCAE-8676E903C207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8" creationId="{D622BBC7-0991-ED56-FDB8-251651B1C64E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9" creationId="{926C9AE2-1916-4490-A534-860017AEC50E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90" creationId="{4B47116D-8C5C-E550-99EC-4C0B7A47AC6B}"/>
          </ac:spMkLst>
        </pc:spChg>
        <pc:spChg chg="mod">
          <ac:chgData name="JUAN MANUEL LOZANO GIL" userId="618ed11e-cb2c-4b03-8ac9-a8cf52f924c9" providerId="ADAL" clId="{2C754AFD-733E-4F0A-A56C-4CCF838AEA10}" dt="2023-07-19T12:27:19.577" v="241"/>
          <ac:spMkLst>
            <pc:docMk/>
            <pc:sldMk cId="236126241" sldId="257"/>
            <ac:spMk id="97" creationId="{35494226-F88F-EB79-62C1-F164BC2B2A0A}"/>
          </ac:spMkLst>
        </pc:spChg>
        <pc:spChg chg="mod">
          <ac:chgData name="JUAN MANUEL LOZANO GIL" userId="618ed11e-cb2c-4b03-8ac9-a8cf52f924c9" providerId="ADAL" clId="{2C754AFD-733E-4F0A-A56C-4CCF838AEA10}" dt="2023-07-19T12:27:19.577" v="241"/>
          <ac:spMkLst>
            <pc:docMk/>
            <pc:sldMk cId="236126241" sldId="257"/>
            <ac:spMk id="98" creationId="{BE3B2D01-FE87-52B5-FF92-4ACACF3D3C3E}"/>
          </ac:spMkLst>
        </pc:spChg>
        <pc:spChg chg="mod">
          <ac:chgData name="JUAN MANUEL LOZANO GIL" userId="618ed11e-cb2c-4b03-8ac9-a8cf52f924c9" providerId="ADAL" clId="{2C754AFD-733E-4F0A-A56C-4CCF838AEA10}" dt="2023-07-19T12:27:19.577" v="241"/>
          <ac:spMkLst>
            <pc:docMk/>
            <pc:sldMk cId="236126241" sldId="257"/>
            <ac:spMk id="99" creationId="{C856674C-8346-A320-1D81-4515FC19ACCD}"/>
          </ac:spMkLst>
        </pc:spChg>
        <pc:spChg chg="mod">
          <ac:chgData name="JUAN MANUEL LOZANO GIL" userId="618ed11e-cb2c-4b03-8ac9-a8cf52f924c9" providerId="ADAL" clId="{2C754AFD-733E-4F0A-A56C-4CCF838AEA10}" dt="2023-07-19T12:27:19.577" v="241"/>
          <ac:spMkLst>
            <pc:docMk/>
            <pc:sldMk cId="236126241" sldId="257"/>
            <ac:spMk id="100" creationId="{D17C37FB-3A21-317D-90A7-838E6E866E55}"/>
          </ac:spMkLst>
        </pc:spChg>
        <pc:spChg chg="mod">
          <ac:chgData name="JUAN MANUEL LOZANO GIL" userId="618ed11e-cb2c-4b03-8ac9-a8cf52f924c9" providerId="ADAL" clId="{2C754AFD-733E-4F0A-A56C-4CCF838AEA10}" dt="2023-07-19T12:27:19.577" v="241"/>
          <ac:spMkLst>
            <pc:docMk/>
            <pc:sldMk cId="236126241" sldId="257"/>
            <ac:spMk id="101" creationId="{59F67548-5A65-5136-6217-E9D2F25207BE}"/>
          </ac:spMkLst>
        </pc:spChg>
        <pc:spChg chg="mod">
          <ac:chgData name="JUAN MANUEL LOZANO GIL" userId="618ed11e-cb2c-4b03-8ac9-a8cf52f924c9" providerId="ADAL" clId="{2C754AFD-733E-4F0A-A56C-4CCF838AEA10}" dt="2023-07-19T12:27:19.577" v="241"/>
          <ac:spMkLst>
            <pc:docMk/>
            <pc:sldMk cId="236126241" sldId="257"/>
            <ac:spMk id="102" creationId="{887B108D-B102-96CD-32F0-192E66B9CE55}"/>
          </ac:spMkLst>
        </pc:spChg>
        <pc:spChg chg="mod">
          <ac:chgData name="JUAN MANUEL LOZANO GIL" userId="618ed11e-cb2c-4b03-8ac9-a8cf52f924c9" providerId="ADAL" clId="{2C754AFD-733E-4F0A-A56C-4CCF838AEA10}" dt="2023-07-19T12:27:19.577" v="241"/>
          <ac:spMkLst>
            <pc:docMk/>
            <pc:sldMk cId="236126241" sldId="257"/>
            <ac:spMk id="103" creationId="{F2CA8EB3-90D8-E3CA-DF1D-24CB13506E39}"/>
          </ac:spMkLst>
        </pc:spChg>
        <pc:spChg chg="add mod">
          <ac:chgData name="JUAN MANUEL LOZANO GIL" userId="618ed11e-cb2c-4b03-8ac9-a8cf52f924c9" providerId="ADAL" clId="{2C754AFD-733E-4F0A-A56C-4CCF838AEA10}" dt="2023-07-19T12:27:38.141" v="244" actId="1076"/>
          <ac:spMkLst>
            <pc:docMk/>
            <pc:sldMk cId="236126241" sldId="257"/>
            <ac:spMk id="111" creationId="{639D055B-F362-C4D7-03B5-C623AAFF4CA5}"/>
          </ac:spMkLst>
        </pc:spChg>
        <pc:spChg chg="add mod">
          <ac:chgData name="JUAN MANUEL LOZANO GIL" userId="618ed11e-cb2c-4b03-8ac9-a8cf52f924c9" providerId="ADAL" clId="{2C754AFD-733E-4F0A-A56C-4CCF838AEA10}" dt="2023-07-19T12:27:49.349" v="253" actId="20577"/>
          <ac:spMkLst>
            <pc:docMk/>
            <pc:sldMk cId="236126241" sldId="257"/>
            <ac:spMk id="112" creationId="{17DE7CD4-CEF5-1A3C-4405-DC9E90863427}"/>
          </ac:spMkLst>
        </pc:spChg>
        <pc:spChg chg="add mod">
          <ac:chgData name="JUAN MANUEL LOZANO GIL" userId="618ed11e-cb2c-4b03-8ac9-a8cf52f924c9" providerId="ADAL" clId="{2C754AFD-733E-4F0A-A56C-4CCF838AEA10}" dt="2023-07-19T12:27:58.589" v="274" actId="20577"/>
          <ac:spMkLst>
            <pc:docMk/>
            <pc:sldMk cId="236126241" sldId="257"/>
            <ac:spMk id="113" creationId="{B9F64BC0-143F-F0DC-D338-6209797FBA4D}"/>
          </ac:spMkLst>
        </pc:spChg>
        <pc:spChg chg="add mod">
          <ac:chgData name="JUAN MANUEL LOZANO GIL" userId="618ed11e-cb2c-4b03-8ac9-a8cf52f924c9" providerId="ADAL" clId="{2C754AFD-733E-4F0A-A56C-4CCF838AEA10}" dt="2023-07-19T12:31:02.128" v="295" actId="1038"/>
          <ac:spMkLst>
            <pc:docMk/>
            <pc:sldMk cId="236126241" sldId="257"/>
            <ac:spMk id="115" creationId="{E793D70F-9D4F-DC80-0EF0-00F9547C648D}"/>
          </ac:spMkLst>
        </pc:spChg>
        <pc:spChg chg="mod">
          <ac:chgData name="JUAN MANUEL LOZANO GIL" userId="618ed11e-cb2c-4b03-8ac9-a8cf52f924c9" providerId="ADAL" clId="{2C754AFD-733E-4F0A-A56C-4CCF838AEA10}" dt="2023-07-19T12:32:06.259" v="309"/>
          <ac:spMkLst>
            <pc:docMk/>
            <pc:sldMk cId="236126241" sldId="257"/>
            <ac:spMk id="123" creationId="{4EFDD4F5-A310-5A9D-D0D8-3EB1A1F51018}"/>
          </ac:spMkLst>
        </pc:spChg>
        <pc:spChg chg="mod">
          <ac:chgData name="JUAN MANUEL LOZANO GIL" userId="618ed11e-cb2c-4b03-8ac9-a8cf52f924c9" providerId="ADAL" clId="{2C754AFD-733E-4F0A-A56C-4CCF838AEA10}" dt="2023-07-19T12:32:06.259" v="309"/>
          <ac:spMkLst>
            <pc:docMk/>
            <pc:sldMk cId="236126241" sldId="257"/>
            <ac:spMk id="124" creationId="{C0CAD623-1A46-A801-44D6-6CF913CB1CE1}"/>
          </ac:spMkLst>
        </pc:spChg>
        <pc:spChg chg="mod">
          <ac:chgData name="JUAN MANUEL LOZANO GIL" userId="618ed11e-cb2c-4b03-8ac9-a8cf52f924c9" providerId="ADAL" clId="{2C754AFD-733E-4F0A-A56C-4CCF838AEA10}" dt="2023-07-19T12:32:06.259" v="309"/>
          <ac:spMkLst>
            <pc:docMk/>
            <pc:sldMk cId="236126241" sldId="257"/>
            <ac:spMk id="125" creationId="{63692FFD-C2A6-492D-F288-F2585429AF8E}"/>
          </ac:spMkLst>
        </pc:spChg>
        <pc:spChg chg="mod">
          <ac:chgData name="JUAN MANUEL LOZANO GIL" userId="618ed11e-cb2c-4b03-8ac9-a8cf52f924c9" providerId="ADAL" clId="{2C754AFD-733E-4F0A-A56C-4CCF838AEA10}" dt="2023-07-19T12:32:06.259" v="309"/>
          <ac:spMkLst>
            <pc:docMk/>
            <pc:sldMk cId="236126241" sldId="257"/>
            <ac:spMk id="126" creationId="{EC4458D4-FBD8-6190-6B26-3D00D1D89286}"/>
          </ac:spMkLst>
        </pc:spChg>
        <pc:spChg chg="mod">
          <ac:chgData name="JUAN MANUEL LOZANO GIL" userId="618ed11e-cb2c-4b03-8ac9-a8cf52f924c9" providerId="ADAL" clId="{2C754AFD-733E-4F0A-A56C-4CCF838AEA10}" dt="2023-07-19T12:32:06.259" v="309"/>
          <ac:spMkLst>
            <pc:docMk/>
            <pc:sldMk cId="236126241" sldId="257"/>
            <ac:spMk id="127" creationId="{961280BA-7786-8C92-D276-A40CC0886686}"/>
          </ac:spMkLst>
        </pc:spChg>
        <pc:spChg chg="del mod">
          <ac:chgData name="JUAN MANUEL LOZANO GIL" userId="618ed11e-cb2c-4b03-8ac9-a8cf52f924c9" providerId="ADAL" clId="{2C754AFD-733E-4F0A-A56C-4CCF838AEA10}" dt="2023-07-19T13:21:40.165" v="373" actId="478"/>
          <ac:spMkLst>
            <pc:docMk/>
            <pc:sldMk cId="236126241" sldId="257"/>
            <ac:spMk id="128" creationId="{964CA77A-DC57-B783-3517-A2254AFE9958}"/>
          </ac:spMkLst>
        </pc:spChg>
        <pc:spChg chg="del mod">
          <ac:chgData name="JUAN MANUEL LOZANO GIL" userId="618ed11e-cb2c-4b03-8ac9-a8cf52f924c9" providerId="ADAL" clId="{2C754AFD-733E-4F0A-A56C-4CCF838AEA10}" dt="2023-07-19T13:21:41.669" v="374" actId="478"/>
          <ac:spMkLst>
            <pc:docMk/>
            <pc:sldMk cId="236126241" sldId="257"/>
            <ac:spMk id="129" creationId="{DED6A395-8D45-F228-8E64-9FABFAAD2333}"/>
          </ac:spMkLst>
        </pc:spChg>
        <pc:spChg chg="add mod">
          <ac:chgData name="JUAN MANUEL LOZANO GIL" userId="618ed11e-cb2c-4b03-8ac9-a8cf52f924c9" providerId="ADAL" clId="{2C754AFD-733E-4F0A-A56C-4CCF838AEA10}" dt="2023-07-19T12:32:42.436" v="368" actId="20577"/>
          <ac:spMkLst>
            <pc:docMk/>
            <pc:sldMk cId="236126241" sldId="257"/>
            <ac:spMk id="137" creationId="{132FFF07-291A-65D4-EBB7-545D316F222E}"/>
          </ac:spMkLst>
        </pc:spChg>
        <pc:grpChg chg="add mod">
          <ac:chgData name="JUAN MANUEL LOZANO GIL" userId="618ed11e-cb2c-4b03-8ac9-a8cf52f924c9" providerId="ADAL" clId="{2C754AFD-733E-4F0A-A56C-4CCF838AEA10}" dt="2023-07-19T12:27:02.029" v="236" actId="1076"/>
          <ac:grpSpMkLst>
            <pc:docMk/>
            <pc:sldMk cId="236126241" sldId="257"/>
            <ac:grpSpMk id="6" creationId="{80952FC4-A08B-B3D7-D07B-CE6C844A14A9}"/>
          </ac:grpSpMkLst>
        </pc:grpChg>
        <pc:grpChg chg="mod">
          <ac:chgData name="JUAN MANUEL LOZANO GIL" userId="618ed11e-cb2c-4b03-8ac9-a8cf52f924c9" providerId="ADAL" clId="{2C754AFD-733E-4F0A-A56C-4CCF838AEA10}" dt="2023-07-19T12:27:02.029" v="236" actId="1076"/>
          <ac:grpSpMkLst>
            <pc:docMk/>
            <pc:sldMk cId="236126241" sldId="257"/>
            <ac:grpSpMk id="8" creationId="{6ECEC6D2-B89B-EC32-D2E5-16233731C6B3}"/>
          </ac:grpSpMkLst>
        </pc:grpChg>
        <pc:grpChg chg="mod">
          <ac:chgData name="JUAN MANUEL LOZANO GIL" userId="618ed11e-cb2c-4b03-8ac9-a8cf52f924c9" providerId="ADAL" clId="{2C754AFD-733E-4F0A-A56C-4CCF838AEA10}" dt="2023-07-19T12:16:44.860" v="10"/>
          <ac:grpSpMkLst>
            <pc:docMk/>
            <pc:sldMk cId="236126241" sldId="257"/>
            <ac:grpSpMk id="17" creationId="{6455B4FE-16A5-904F-4250-A5C54999BF2A}"/>
          </ac:grpSpMkLst>
        </pc:grpChg>
        <pc:grpChg chg="add mod">
          <ac:chgData name="JUAN MANUEL LOZANO GIL" userId="618ed11e-cb2c-4b03-8ac9-a8cf52f924c9" providerId="ADAL" clId="{2C754AFD-733E-4F0A-A56C-4CCF838AEA10}" dt="2023-07-19T12:27:02.029" v="236" actId="1076"/>
          <ac:grpSpMkLst>
            <pc:docMk/>
            <pc:sldMk cId="236126241" sldId="257"/>
            <ac:grpSpMk id="55" creationId="{310D0092-15C0-5BAC-78B3-2FF9B3258CF6}"/>
          </ac:grpSpMkLst>
        </pc:grpChg>
        <pc:grpChg chg="add mod">
          <ac:chgData name="JUAN MANUEL LOZANO GIL" userId="618ed11e-cb2c-4b03-8ac9-a8cf52f924c9" providerId="ADAL" clId="{2C754AFD-733E-4F0A-A56C-4CCF838AEA10}" dt="2023-07-19T12:27:12.532" v="239" actId="1076"/>
          <ac:grpSpMkLst>
            <pc:docMk/>
            <pc:sldMk cId="236126241" sldId="257"/>
            <ac:grpSpMk id="63" creationId="{B51C5646-7A41-6ABE-0BD8-D3D0365DF8F3}"/>
          </ac:grpSpMkLst>
        </pc:grpChg>
        <pc:grpChg chg="mod">
          <ac:chgData name="JUAN MANUEL LOZANO GIL" userId="618ed11e-cb2c-4b03-8ac9-a8cf52f924c9" providerId="ADAL" clId="{2C754AFD-733E-4F0A-A56C-4CCF838AEA10}" dt="2023-07-19T12:23:07.099" v="95"/>
          <ac:grpSpMkLst>
            <pc:docMk/>
            <pc:sldMk cId="236126241" sldId="257"/>
            <ac:grpSpMk id="64" creationId="{1075AE8B-341E-AFAD-D913-A6A8B22A5847}"/>
          </ac:grpSpMkLst>
        </pc:grpChg>
        <pc:grpChg chg="add del mod">
          <ac:chgData name="JUAN MANUEL LOZANO GIL" userId="618ed11e-cb2c-4b03-8ac9-a8cf52f924c9" providerId="ADAL" clId="{2C754AFD-733E-4F0A-A56C-4CCF838AEA10}" dt="2023-07-19T12:27:06.420" v="238" actId="478"/>
          <ac:grpSpMkLst>
            <pc:docMk/>
            <pc:sldMk cId="236126241" sldId="257"/>
            <ac:grpSpMk id="80" creationId="{530C55CE-1A1B-B605-F056-8A0F7CB03741}"/>
          </ac:grpSpMkLst>
        </pc:grpChg>
        <pc:grpChg chg="add mod">
          <ac:chgData name="JUAN MANUEL LOZANO GIL" userId="618ed11e-cb2c-4b03-8ac9-a8cf52f924c9" providerId="ADAL" clId="{2C754AFD-733E-4F0A-A56C-4CCF838AEA10}" dt="2023-07-19T12:27:26.230" v="242" actId="1076"/>
          <ac:grpSpMkLst>
            <pc:docMk/>
            <pc:sldMk cId="236126241" sldId="257"/>
            <ac:grpSpMk id="95" creationId="{9A88576D-03BD-A42B-E63C-E85294663A8C}"/>
          </ac:grpSpMkLst>
        </pc:grpChg>
        <pc:grpChg chg="mod">
          <ac:chgData name="JUAN MANUEL LOZANO GIL" userId="618ed11e-cb2c-4b03-8ac9-a8cf52f924c9" providerId="ADAL" clId="{2C754AFD-733E-4F0A-A56C-4CCF838AEA10}" dt="2023-07-19T12:27:19.577" v="241"/>
          <ac:grpSpMkLst>
            <pc:docMk/>
            <pc:sldMk cId="236126241" sldId="257"/>
            <ac:grpSpMk id="96" creationId="{4B3DF87F-D8DD-2DA7-B47B-6D34F3CDBB29}"/>
          </ac:grpSpMkLst>
        </pc:grpChg>
        <pc:grpChg chg="add del mod">
          <ac:chgData name="JUAN MANUEL LOZANO GIL" userId="618ed11e-cb2c-4b03-8ac9-a8cf52f924c9" providerId="ADAL" clId="{2C754AFD-733E-4F0A-A56C-4CCF838AEA10}" dt="2023-07-19T12:32:27.701" v="349" actId="478"/>
          <ac:grpSpMkLst>
            <pc:docMk/>
            <pc:sldMk cId="236126241" sldId="257"/>
            <ac:grpSpMk id="120" creationId="{3F9F9ABB-BDB0-4862-294F-0EECDA83AD17}"/>
          </ac:grpSpMkLst>
        </pc:grpChg>
        <pc:grpChg chg="add mod">
          <ac:chgData name="JUAN MANUEL LOZANO GIL" userId="618ed11e-cb2c-4b03-8ac9-a8cf52f924c9" providerId="ADAL" clId="{2C754AFD-733E-4F0A-A56C-4CCF838AEA10}" dt="2023-07-19T12:32:25.537" v="348" actId="1038"/>
          <ac:grpSpMkLst>
            <pc:docMk/>
            <pc:sldMk cId="236126241" sldId="257"/>
            <ac:grpSpMk id="121" creationId="{F7DD65EB-E362-A17D-3E97-08606792C1C6}"/>
          </ac:grpSpMkLst>
        </pc:grpChg>
        <pc:grpChg chg="mod">
          <ac:chgData name="JUAN MANUEL LOZANO GIL" userId="618ed11e-cb2c-4b03-8ac9-a8cf52f924c9" providerId="ADAL" clId="{2C754AFD-733E-4F0A-A56C-4CCF838AEA10}" dt="2023-07-19T12:32:06.259" v="309"/>
          <ac:grpSpMkLst>
            <pc:docMk/>
            <pc:sldMk cId="236126241" sldId="257"/>
            <ac:grpSpMk id="122" creationId="{1C32FCD2-50E1-2A71-B970-B936B563E03A}"/>
          </ac:grpSpMkLst>
        </pc:grpChg>
        <pc:picChg chg="add del mod modCrop">
          <ac:chgData name="JUAN MANUEL LOZANO GIL" userId="618ed11e-cb2c-4b03-8ac9-a8cf52f924c9" providerId="ADAL" clId="{2C754AFD-733E-4F0A-A56C-4CCF838AEA10}" dt="2023-07-19T13:26:29.631" v="379" actId="21"/>
          <ac:picMkLst>
            <pc:docMk/>
            <pc:sldMk cId="236126241" sldId="257"/>
            <ac:picMk id="2" creationId="{096214D9-8691-71E8-5C7B-443E671AA0C2}"/>
          </ac:picMkLst>
        </pc:picChg>
        <pc:picChg chg="add mod modCrop">
          <ac:chgData name="JUAN MANUEL LOZANO GIL" userId="618ed11e-cb2c-4b03-8ac9-a8cf52f924c9" providerId="ADAL" clId="{2C754AFD-733E-4F0A-A56C-4CCF838AEA10}" dt="2023-07-19T12:27:02.029" v="236" actId="1076"/>
          <ac:picMkLst>
            <pc:docMk/>
            <pc:sldMk cId="236126241" sldId="257"/>
            <ac:picMk id="3" creationId="{42A409BF-BF62-2408-5370-A1AC57EDC83F}"/>
          </ac:picMkLst>
        </pc:picChg>
        <pc:picChg chg="add del mod ord">
          <ac:chgData name="JUAN MANUEL LOZANO GIL" userId="618ed11e-cb2c-4b03-8ac9-a8cf52f924c9" providerId="ADAL" clId="{2C754AFD-733E-4F0A-A56C-4CCF838AEA10}" dt="2023-07-19T12:17:14.510" v="21" actId="478"/>
          <ac:picMkLst>
            <pc:docMk/>
            <pc:sldMk cId="236126241" sldId="257"/>
            <ac:picMk id="5" creationId="{A2560D1A-CD36-E40B-49D1-9EC6256B9DEB}"/>
          </ac:picMkLst>
        </pc:picChg>
        <pc:picChg chg="del">
          <ac:chgData name="JUAN MANUEL LOZANO GIL" userId="618ed11e-cb2c-4b03-8ac9-a8cf52f924c9" providerId="ADAL" clId="{2C754AFD-733E-4F0A-A56C-4CCF838AEA10}" dt="2023-07-19T12:16:22.607" v="0" actId="478"/>
          <ac:picMkLst>
            <pc:docMk/>
            <pc:sldMk cId="236126241" sldId="257"/>
            <ac:picMk id="7" creationId="{249F3737-2ECA-678D-A59E-494C5B48DC52}"/>
          </ac:picMkLst>
        </pc:picChg>
        <pc:picChg chg="add mod ord modCrop">
          <ac:chgData name="JUAN MANUEL LOZANO GIL" userId="618ed11e-cb2c-4b03-8ac9-a8cf52f924c9" providerId="ADAL" clId="{2C754AFD-733E-4F0A-A56C-4CCF838AEA10}" dt="2023-07-19T12:27:02.029" v="236" actId="1076"/>
          <ac:picMkLst>
            <pc:docMk/>
            <pc:sldMk cId="236126241" sldId="257"/>
            <ac:picMk id="57" creationId="{1219A44C-029A-7585-8F53-35D405D37E24}"/>
          </ac:picMkLst>
        </pc:picChg>
        <pc:picChg chg="add mod modCrop">
          <ac:chgData name="JUAN MANUEL LOZANO GIL" userId="618ed11e-cb2c-4b03-8ac9-a8cf52f924c9" providerId="ADAL" clId="{2C754AFD-733E-4F0A-A56C-4CCF838AEA10}" dt="2023-07-19T12:27:12.532" v="239" actId="1076"/>
          <ac:picMkLst>
            <pc:docMk/>
            <pc:sldMk cId="236126241" sldId="257"/>
            <ac:picMk id="62" creationId="{F2141D81-4FA9-8618-E836-00E38748E7EF}"/>
          </ac:picMkLst>
        </pc:picChg>
        <pc:picChg chg="add del mod">
          <ac:chgData name="JUAN MANUEL LOZANO GIL" userId="618ed11e-cb2c-4b03-8ac9-a8cf52f924c9" providerId="ADAL" clId="{2C754AFD-733E-4F0A-A56C-4CCF838AEA10}" dt="2023-07-19T12:26:34.901" v="231" actId="478"/>
          <ac:picMkLst>
            <pc:docMk/>
            <pc:sldMk cId="236126241" sldId="257"/>
            <ac:picMk id="92" creationId="{7B793B6A-E421-496D-D7AF-67EBC04DDE26}"/>
          </ac:picMkLst>
        </pc:picChg>
        <pc:picChg chg="add mod modCrop">
          <ac:chgData name="JUAN MANUEL LOZANO GIL" userId="618ed11e-cb2c-4b03-8ac9-a8cf52f924c9" providerId="ADAL" clId="{2C754AFD-733E-4F0A-A56C-4CCF838AEA10}" dt="2023-07-19T12:28:02.260" v="275" actId="208"/>
          <ac:picMkLst>
            <pc:docMk/>
            <pc:sldMk cId="236126241" sldId="257"/>
            <ac:picMk id="94" creationId="{430E5B00-1908-D489-1059-7458EC9A0E10}"/>
          </ac:picMkLst>
        </pc:picChg>
        <pc:picChg chg="add mod modCrop">
          <ac:chgData name="JUAN MANUEL LOZANO GIL" userId="618ed11e-cb2c-4b03-8ac9-a8cf52f924c9" providerId="ADAL" clId="{2C754AFD-733E-4F0A-A56C-4CCF838AEA10}" dt="2023-07-19T13:21:33.477" v="369" actId="732"/>
          <ac:picMkLst>
            <pc:docMk/>
            <pc:sldMk cId="236126241" sldId="257"/>
            <ac:picMk id="114" creationId="{988EA5B1-B066-B493-0A18-66216AB290AC}"/>
          </ac:picMkLst>
        </pc:picChg>
        <pc:picChg chg="add mod">
          <ac:chgData name="JUAN MANUEL LOZANO GIL" userId="618ed11e-cb2c-4b03-8ac9-a8cf52f924c9" providerId="ADAL" clId="{2C754AFD-733E-4F0A-A56C-4CCF838AEA10}" dt="2023-07-19T12:31:53.639" v="306" actId="164"/>
          <ac:picMkLst>
            <pc:docMk/>
            <pc:sldMk cId="236126241" sldId="257"/>
            <ac:picMk id="117" creationId="{DE3B0CA6-A20F-1714-B3C2-1AD12A10E4C3}"/>
          </ac:picMkLst>
        </pc:picChg>
        <pc:picChg chg="add mod">
          <ac:chgData name="JUAN MANUEL LOZANO GIL" userId="618ed11e-cb2c-4b03-8ac9-a8cf52f924c9" providerId="ADAL" clId="{2C754AFD-733E-4F0A-A56C-4CCF838AEA10}" dt="2023-07-19T12:31:53.639" v="306" actId="164"/>
          <ac:picMkLst>
            <pc:docMk/>
            <pc:sldMk cId="236126241" sldId="257"/>
            <ac:picMk id="119" creationId="{E8AC02B2-6B6B-9B10-0F9F-B0ACBE6189F5}"/>
          </ac:picMkLst>
        </pc:picChg>
        <pc:cxnChg chg="mod">
          <ac:chgData name="JUAN MANUEL LOZANO GIL" userId="618ed11e-cb2c-4b03-8ac9-a8cf52f924c9" providerId="ADAL" clId="{2C754AFD-733E-4F0A-A56C-4CCF838AEA10}" dt="2023-07-19T12:24:12.958" v="207" actId="1036"/>
          <ac:cxnSpMkLst>
            <pc:docMk/>
            <pc:sldMk cId="236126241" sldId="257"/>
            <ac:cxnSpMk id="27" creationId="{73122490-A3EF-1CCF-57A2-73126CB81FBC}"/>
          </ac:cxnSpMkLst>
        </pc:cxnChg>
        <pc:cxnChg chg="del">
          <ac:chgData name="JUAN MANUEL LOZANO GIL" userId="618ed11e-cb2c-4b03-8ac9-a8cf52f924c9" providerId="ADAL" clId="{2C754AFD-733E-4F0A-A56C-4CCF838AEA10}" dt="2023-07-19T12:16:24.606" v="1" actId="478"/>
          <ac:cxnSpMkLst>
            <pc:docMk/>
            <pc:sldMk cId="236126241" sldId="257"/>
            <ac:cxnSpMk id="33" creationId="{6AB4F24E-2418-3177-99FE-E328E98D14F3}"/>
          </ac:cxnSpMkLst>
        </pc:cxnChg>
        <pc:cxnChg chg="mod">
          <ac:chgData name="JUAN MANUEL LOZANO GIL" userId="618ed11e-cb2c-4b03-8ac9-a8cf52f924c9" providerId="ADAL" clId="{2C754AFD-733E-4F0A-A56C-4CCF838AEA10}" dt="2023-07-19T12:16:44.860" v="10"/>
          <ac:cxnSpMkLst>
            <pc:docMk/>
            <pc:sldMk cId="236126241" sldId="257"/>
            <ac:cxnSpMk id="37" creationId="{DF18E5A8-3C20-F91C-9330-3CA751B7F91C}"/>
          </ac:cxnSpMkLst>
        </pc:cxnChg>
        <pc:cxnChg chg="mod">
          <ac:chgData name="JUAN MANUEL LOZANO GIL" userId="618ed11e-cb2c-4b03-8ac9-a8cf52f924c9" providerId="ADAL" clId="{2C754AFD-733E-4F0A-A56C-4CCF838AEA10}" dt="2023-07-19T12:16:55.935" v="17" actId="1035"/>
          <ac:cxnSpMkLst>
            <pc:docMk/>
            <pc:sldMk cId="236126241" sldId="257"/>
            <ac:cxnSpMk id="38" creationId="{F12B26A2-6E5B-FA81-00BD-C1F290B8598A}"/>
          </ac:cxnSpMkLst>
        </pc:cxnChg>
        <pc:cxnChg chg="mod">
          <ac:chgData name="JUAN MANUEL LOZANO GIL" userId="618ed11e-cb2c-4b03-8ac9-a8cf52f924c9" providerId="ADAL" clId="{2C754AFD-733E-4F0A-A56C-4CCF838AEA10}" dt="2023-07-19T12:16:44.860" v="10"/>
          <ac:cxnSpMkLst>
            <pc:docMk/>
            <pc:sldMk cId="236126241" sldId="257"/>
            <ac:cxnSpMk id="39" creationId="{259E7E14-5B40-8674-882B-2222280D664F}"/>
          </ac:cxnSpMkLst>
        </pc:cxnChg>
        <pc:cxnChg chg="mod">
          <ac:chgData name="JUAN MANUEL LOZANO GIL" userId="618ed11e-cb2c-4b03-8ac9-a8cf52f924c9" providerId="ADAL" clId="{2C754AFD-733E-4F0A-A56C-4CCF838AEA10}" dt="2023-07-19T12:16:44.860" v="10"/>
          <ac:cxnSpMkLst>
            <pc:docMk/>
            <pc:sldMk cId="236126241" sldId="257"/>
            <ac:cxnSpMk id="40" creationId="{05F33000-8D74-1AD7-6444-941A53DB300E}"/>
          </ac:cxnSpMkLst>
        </pc:cxnChg>
        <pc:cxnChg chg="del mod">
          <ac:chgData name="JUAN MANUEL LOZANO GIL" userId="618ed11e-cb2c-4b03-8ac9-a8cf52f924c9" providerId="ADAL" clId="{2C754AFD-733E-4F0A-A56C-4CCF838AEA10}" dt="2023-07-19T12:17:49.207" v="31" actId="478"/>
          <ac:cxnSpMkLst>
            <pc:docMk/>
            <pc:sldMk cId="236126241" sldId="257"/>
            <ac:cxnSpMk id="41" creationId="{43D52F60-1132-575F-2595-92DBFDD0D155}"/>
          </ac:cxnSpMkLst>
        </pc:cxnChg>
        <pc:cxnChg chg="del mod">
          <ac:chgData name="JUAN MANUEL LOZANO GIL" userId="618ed11e-cb2c-4b03-8ac9-a8cf52f924c9" providerId="ADAL" clId="{2C754AFD-733E-4F0A-A56C-4CCF838AEA10}" dt="2023-07-19T12:17:47.063" v="30" actId="478"/>
          <ac:cxnSpMkLst>
            <pc:docMk/>
            <pc:sldMk cId="236126241" sldId="257"/>
            <ac:cxnSpMk id="42" creationId="{A974288E-379A-34C6-F048-6DDF7B40580E}"/>
          </ac:cxnSpMkLst>
        </pc:cxnChg>
        <pc:cxnChg chg="del mod">
          <ac:chgData name="JUAN MANUEL LOZANO GIL" userId="618ed11e-cb2c-4b03-8ac9-a8cf52f924c9" providerId="ADAL" clId="{2C754AFD-733E-4F0A-A56C-4CCF838AEA10}" dt="2023-07-19T12:17:42.519" v="27" actId="478"/>
          <ac:cxnSpMkLst>
            <pc:docMk/>
            <pc:sldMk cId="236126241" sldId="257"/>
            <ac:cxnSpMk id="43" creationId="{8495E7F3-A12B-655E-728E-366E991C17AB}"/>
          </ac:cxnSpMkLst>
        </pc:cxnChg>
        <pc:cxnChg chg="mod">
          <ac:chgData name="JUAN MANUEL LOZANO GIL" userId="618ed11e-cb2c-4b03-8ac9-a8cf52f924c9" providerId="ADAL" clId="{2C754AFD-733E-4F0A-A56C-4CCF838AEA10}" dt="2023-07-19T12:23:31.599" v="102" actId="1035"/>
          <ac:cxnSpMkLst>
            <pc:docMk/>
            <pc:sldMk cId="236126241" sldId="257"/>
            <ac:cxnSpMk id="72" creationId="{9062BE9B-9E10-D835-FA50-B05DA551B59D}"/>
          </ac:cxnSpMkLst>
        </pc:cxnChg>
        <pc:cxnChg chg="mod">
          <ac:chgData name="JUAN MANUEL LOZANO GIL" userId="618ed11e-cb2c-4b03-8ac9-a8cf52f924c9" providerId="ADAL" clId="{2C754AFD-733E-4F0A-A56C-4CCF838AEA10}" dt="2023-07-19T12:23:37.743" v="123" actId="1036"/>
          <ac:cxnSpMkLst>
            <pc:docMk/>
            <pc:sldMk cId="236126241" sldId="257"/>
            <ac:cxnSpMk id="73" creationId="{180CFFF9-77ED-F079-90C7-33E207643A5B}"/>
          </ac:cxnSpMkLst>
        </pc:cxnChg>
        <pc:cxnChg chg="mod">
          <ac:chgData name="JUAN MANUEL LOZANO GIL" userId="618ed11e-cb2c-4b03-8ac9-a8cf52f924c9" providerId="ADAL" clId="{2C754AFD-733E-4F0A-A56C-4CCF838AEA10}" dt="2023-07-19T12:23:41.318" v="133" actId="1035"/>
          <ac:cxnSpMkLst>
            <pc:docMk/>
            <pc:sldMk cId="236126241" sldId="257"/>
            <ac:cxnSpMk id="74" creationId="{63941729-08C1-D7C8-88D7-E976BF5EA169}"/>
          </ac:cxnSpMkLst>
        </pc:cxnChg>
        <pc:cxnChg chg="mod">
          <ac:chgData name="JUAN MANUEL LOZANO GIL" userId="618ed11e-cb2c-4b03-8ac9-a8cf52f924c9" providerId="ADAL" clId="{2C754AFD-733E-4F0A-A56C-4CCF838AEA10}" dt="2023-07-19T12:23:50.342" v="153" actId="1035"/>
          <ac:cxnSpMkLst>
            <pc:docMk/>
            <pc:sldMk cId="236126241" sldId="257"/>
            <ac:cxnSpMk id="75" creationId="{B6A8A7B0-86FE-E44E-B623-15AD9865DC63}"/>
          </ac:cxnSpMkLst>
        </pc:cxnChg>
        <pc:cxnChg chg="mod">
          <ac:chgData name="JUAN MANUEL LOZANO GIL" userId="618ed11e-cb2c-4b03-8ac9-a8cf52f924c9" providerId="ADAL" clId="{2C754AFD-733E-4F0A-A56C-4CCF838AEA10}" dt="2023-07-19T12:24:34.847" v="214" actId="1035"/>
          <ac:cxnSpMkLst>
            <pc:docMk/>
            <pc:sldMk cId="236126241" sldId="257"/>
            <ac:cxnSpMk id="76" creationId="{3492D2D1-34BB-14BF-E35A-1D4C26308134}"/>
          </ac:cxnSpMkLst>
        </pc:cxnChg>
        <pc:cxnChg chg="mod">
          <ac:chgData name="JUAN MANUEL LOZANO GIL" userId="618ed11e-cb2c-4b03-8ac9-a8cf52f924c9" providerId="ADAL" clId="{2C754AFD-733E-4F0A-A56C-4CCF838AEA10}" dt="2023-07-19T12:23:59.784" v="179" actId="1036"/>
          <ac:cxnSpMkLst>
            <pc:docMk/>
            <pc:sldMk cId="236126241" sldId="257"/>
            <ac:cxnSpMk id="77" creationId="{6B68C81B-783E-A086-A5F7-C0B112D558B9}"/>
          </ac:cxnSpMkLst>
        </pc:cxnChg>
        <pc:cxnChg chg="mod">
          <ac:chgData name="JUAN MANUEL LOZANO GIL" userId="618ed11e-cb2c-4b03-8ac9-a8cf52f924c9" providerId="ADAL" clId="{2C754AFD-733E-4F0A-A56C-4CCF838AEA10}" dt="2023-07-19T12:24:04.486" v="189" actId="1036"/>
          <ac:cxnSpMkLst>
            <pc:docMk/>
            <pc:sldMk cId="236126241" sldId="257"/>
            <ac:cxnSpMk id="78" creationId="{0D5D2EB7-6300-07EC-5D1C-A6EC85433634}"/>
          </ac:cxnSpMkLst>
        </pc:cxnChg>
        <pc:cxnChg chg="mod">
          <ac:chgData name="JUAN MANUEL LOZANO GIL" userId="618ed11e-cb2c-4b03-8ac9-a8cf52f924c9" providerId="ADAL" clId="{2C754AFD-733E-4F0A-A56C-4CCF838AEA10}" dt="2023-07-19T12:27:19.577" v="241"/>
          <ac:cxnSpMkLst>
            <pc:docMk/>
            <pc:sldMk cId="236126241" sldId="257"/>
            <ac:cxnSpMk id="104" creationId="{40D41830-67CB-3C72-52FD-467D42572DED}"/>
          </ac:cxnSpMkLst>
        </pc:cxnChg>
        <pc:cxnChg chg="mod">
          <ac:chgData name="JUAN MANUEL LOZANO GIL" userId="618ed11e-cb2c-4b03-8ac9-a8cf52f924c9" providerId="ADAL" clId="{2C754AFD-733E-4F0A-A56C-4CCF838AEA10}" dt="2023-07-19T12:27:19.577" v="241"/>
          <ac:cxnSpMkLst>
            <pc:docMk/>
            <pc:sldMk cId="236126241" sldId="257"/>
            <ac:cxnSpMk id="105" creationId="{2A94A489-27E5-AD34-A159-B35D12E68C16}"/>
          </ac:cxnSpMkLst>
        </pc:cxnChg>
        <pc:cxnChg chg="mod">
          <ac:chgData name="JUAN MANUEL LOZANO GIL" userId="618ed11e-cb2c-4b03-8ac9-a8cf52f924c9" providerId="ADAL" clId="{2C754AFD-733E-4F0A-A56C-4CCF838AEA10}" dt="2023-07-19T12:27:19.577" v="241"/>
          <ac:cxnSpMkLst>
            <pc:docMk/>
            <pc:sldMk cId="236126241" sldId="257"/>
            <ac:cxnSpMk id="106" creationId="{8F41F395-110D-4CAB-A530-99D069A33846}"/>
          </ac:cxnSpMkLst>
        </pc:cxnChg>
        <pc:cxnChg chg="mod">
          <ac:chgData name="JUAN MANUEL LOZANO GIL" userId="618ed11e-cb2c-4b03-8ac9-a8cf52f924c9" providerId="ADAL" clId="{2C754AFD-733E-4F0A-A56C-4CCF838AEA10}" dt="2023-07-19T12:27:19.577" v="241"/>
          <ac:cxnSpMkLst>
            <pc:docMk/>
            <pc:sldMk cId="236126241" sldId="257"/>
            <ac:cxnSpMk id="107" creationId="{996EB4DB-030B-B199-ED06-B064270EA2C2}"/>
          </ac:cxnSpMkLst>
        </pc:cxnChg>
        <pc:cxnChg chg="mod">
          <ac:chgData name="JUAN MANUEL LOZANO GIL" userId="618ed11e-cb2c-4b03-8ac9-a8cf52f924c9" providerId="ADAL" clId="{2C754AFD-733E-4F0A-A56C-4CCF838AEA10}" dt="2023-07-19T12:27:19.577" v="241"/>
          <ac:cxnSpMkLst>
            <pc:docMk/>
            <pc:sldMk cId="236126241" sldId="257"/>
            <ac:cxnSpMk id="108" creationId="{53C76150-5999-E5A9-80AD-9A6205CFEE7D}"/>
          </ac:cxnSpMkLst>
        </pc:cxnChg>
        <pc:cxnChg chg="mod">
          <ac:chgData name="JUAN MANUEL LOZANO GIL" userId="618ed11e-cb2c-4b03-8ac9-a8cf52f924c9" providerId="ADAL" clId="{2C754AFD-733E-4F0A-A56C-4CCF838AEA10}" dt="2023-07-19T12:27:19.577" v="241"/>
          <ac:cxnSpMkLst>
            <pc:docMk/>
            <pc:sldMk cId="236126241" sldId="257"/>
            <ac:cxnSpMk id="109" creationId="{1F475A3C-C14D-01BE-0BCE-524EE951391E}"/>
          </ac:cxnSpMkLst>
        </pc:cxnChg>
        <pc:cxnChg chg="mod">
          <ac:chgData name="JUAN MANUEL LOZANO GIL" userId="618ed11e-cb2c-4b03-8ac9-a8cf52f924c9" providerId="ADAL" clId="{2C754AFD-733E-4F0A-A56C-4CCF838AEA10}" dt="2023-07-19T12:27:19.577" v="241"/>
          <ac:cxnSpMkLst>
            <pc:docMk/>
            <pc:sldMk cId="236126241" sldId="257"/>
            <ac:cxnSpMk id="110" creationId="{CD607DE3-1F26-4AB7-1A61-51F5BB60ABC2}"/>
          </ac:cxnSpMkLst>
        </pc:cxnChg>
        <pc:cxnChg chg="mod">
          <ac:chgData name="JUAN MANUEL LOZANO GIL" userId="618ed11e-cb2c-4b03-8ac9-a8cf52f924c9" providerId="ADAL" clId="{2C754AFD-733E-4F0A-A56C-4CCF838AEA10}" dt="2023-07-19T12:32:06.259" v="309"/>
          <ac:cxnSpMkLst>
            <pc:docMk/>
            <pc:sldMk cId="236126241" sldId="257"/>
            <ac:cxnSpMk id="130" creationId="{9BAE5784-6473-4203-3431-4EA9A566E9F6}"/>
          </ac:cxnSpMkLst>
        </pc:cxnChg>
        <pc:cxnChg chg="mod">
          <ac:chgData name="JUAN MANUEL LOZANO GIL" userId="618ed11e-cb2c-4b03-8ac9-a8cf52f924c9" providerId="ADAL" clId="{2C754AFD-733E-4F0A-A56C-4CCF838AEA10}" dt="2023-07-19T12:32:06.259" v="309"/>
          <ac:cxnSpMkLst>
            <pc:docMk/>
            <pc:sldMk cId="236126241" sldId="257"/>
            <ac:cxnSpMk id="131" creationId="{53B626AC-27CD-74C6-EB4F-7DFCF9E6E038}"/>
          </ac:cxnSpMkLst>
        </pc:cxnChg>
        <pc:cxnChg chg="mod">
          <ac:chgData name="JUAN MANUEL LOZANO GIL" userId="618ed11e-cb2c-4b03-8ac9-a8cf52f924c9" providerId="ADAL" clId="{2C754AFD-733E-4F0A-A56C-4CCF838AEA10}" dt="2023-07-19T12:32:06.259" v="309"/>
          <ac:cxnSpMkLst>
            <pc:docMk/>
            <pc:sldMk cId="236126241" sldId="257"/>
            <ac:cxnSpMk id="132" creationId="{5426DB23-4980-18AC-742B-8E9B370498DB}"/>
          </ac:cxnSpMkLst>
        </pc:cxnChg>
        <pc:cxnChg chg="mod">
          <ac:chgData name="JUAN MANUEL LOZANO GIL" userId="618ed11e-cb2c-4b03-8ac9-a8cf52f924c9" providerId="ADAL" clId="{2C754AFD-733E-4F0A-A56C-4CCF838AEA10}" dt="2023-07-19T12:32:06.259" v="309"/>
          <ac:cxnSpMkLst>
            <pc:docMk/>
            <pc:sldMk cId="236126241" sldId="257"/>
            <ac:cxnSpMk id="133" creationId="{8020D6D1-2C45-7A34-1EA2-5401F73F3D0C}"/>
          </ac:cxnSpMkLst>
        </pc:cxnChg>
        <pc:cxnChg chg="mod">
          <ac:chgData name="JUAN MANUEL LOZANO GIL" userId="618ed11e-cb2c-4b03-8ac9-a8cf52f924c9" providerId="ADAL" clId="{2C754AFD-733E-4F0A-A56C-4CCF838AEA10}" dt="2023-07-19T12:32:06.259" v="309"/>
          <ac:cxnSpMkLst>
            <pc:docMk/>
            <pc:sldMk cId="236126241" sldId="257"/>
            <ac:cxnSpMk id="134" creationId="{75396E36-C0DE-B193-1BF8-BE5F3487E6EC}"/>
          </ac:cxnSpMkLst>
        </pc:cxnChg>
        <pc:cxnChg chg="del mod">
          <ac:chgData name="JUAN MANUEL LOZANO GIL" userId="618ed11e-cb2c-4b03-8ac9-a8cf52f924c9" providerId="ADAL" clId="{2C754AFD-733E-4F0A-A56C-4CCF838AEA10}" dt="2023-07-19T13:21:39.013" v="371" actId="478"/>
          <ac:cxnSpMkLst>
            <pc:docMk/>
            <pc:sldMk cId="236126241" sldId="257"/>
            <ac:cxnSpMk id="135" creationId="{D9C103FF-69FC-FF6E-6796-E296C73BEEE1}"/>
          </ac:cxnSpMkLst>
        </pc:cxnChg>
        <pc:cxnChg chg="del mod">
          <ac:chgData name="JUAN MANUEL LOZANO GIL" userId="618ed11e-cb2c-4b03-8ac9-a8cf52f924c9" providerId="ADAL" clId="{2C754AFD-733E-4F0A-A56C-4CCF838AEA10}" dt="2023-07-19T13:21:37.613" v="370" actId="478"/>
          <ac:cxnSpMkLst>
            <pc:docMk/>
            <pc:sldMk cId="236126241" sldId="257"/>
            <ac:cxnSpMk id="136" creationId="{5E26008F-486E-6FD3-B33E-9FBDF9FFFF4E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76822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321659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648986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32237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82615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29928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34861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538275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6832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483393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57415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3355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Imagen 56" descr="Texto, Carta&#10;&#10;Descripción generada automáticamente">
            <a:extLst>
              <a:ext uri="{FF2B5EF4-FFF2-40B4-BE49-F238E27FC236}">
                <a16:creationId xmlns:a16="http://schemas.microsoft.com/office/drawing/2014/main" id="{1219A44C-029A-7585-8F53-35D405D37E2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98" t="7971" r="28579" b="29478"/>
          <a:stretch/>
        </p:blipFill>
        <p:spPr>
          <a:xfrm>
            <a:off x="1931956" y="2334267"/>
            <a:ext cx="1736678" cy="1498044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8" name="Grupo 7">
            <a:extLst>
              <a:ext uri="{FF2B5EF4-FFF2-40B4-BE49-F238E27FC236}">
                <a16:creationId xmlns:a16="http://schemas.microsoft.com/office/drawing/2014/main" id="{6ECEC6D2-B89B-EC32-D2E5-16233731C6B3}"/>
              </a:ext>
            </a:extLst>
          </p:cNvPr>
          <p:cNvGrpSpPr/>
          <p:nvPr/>
        </p:nvGrpSpPr>
        <p:grpSpPr>
          <a:xfrm>
            <a:off x="1008495" y="2379274"/>
            <a:ext cx="937586" cy="1469204"/>
            <a:chOff x="4476963" y="3219994"/>
            <a:chExt cx="794284" cy="1243410"/>
          </a:xfrm>
        </p:grpSpPr>
        <p:grpSp>
          <p:nvGrpSpPr>
            <p:cNvPr id="9" name="Grupo 8">
              <a:extLst>
                <a:ext uri="{FF2B5EF4-FFF2-40B4-BE49-F238E27FC236}">
                  <a16:creationId xmlns:a16="http://schemas.microsoft.com/office/drawing/2014/main" id="{FBB40FF9-F291-150D-61CF-821F5A252FE8}"/>
                </a:ext>
              </a:extLst>
            </p:cNvPr>
            <p:cNvGrpSpPr/>
            <p:nvPr/>
          </p:nvGrpSpPr>
          <p:grpSpPr>
            <a:xfrm>
              <a:off x="4999646" y="3310666"/>
              <a:ext cx="271601" cy="1034675"/>
              <a:chOff x="4999646" y="3310666"/>
              <a:chExt cx="271601" cy="1034675"/>
            </a:xfrm>
          </p:grpSpPr>
          <p:cxnSp>
            <p:nvCxnSpPr>
              <p:cNvPr id="19" name="Conector recto 18">
                <a:extLst>
                  <a:ext uri="{FF2B5EF4-FFF2-40B4-BE49-F238E27FC236}">
                    <a16:creationId xmlns:a16="http://schemas.microsoft.com/office/drawing/2014/main" id="{6832DE56-29C6-7D0D-9027-606FBE897E9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2" y="3310666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Conector recto 19">
                <a:extLst>
                  <a:ext uri="{FF2B5EF4-FFF2-40B4-BE49-F238E27FC236}">
                    <a16:creationId xmlns:a16="http://schemas.microsoft.com/office/drawing/2014/main" id="{4FC2D830-27B3-DC62-91D0-9648EFE398D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521432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Conector recto 20">
                <a:extLst>
                  <a:ext uri="{FF2B5EF4-FFF2-40B4-BE49-F238E27FC236}">
                    <a16:creationId xmlns:a16="http://schemas.microsoft.com/office/drawing/2014/main" id="{CB9017B7-481F-5B33-8B78-F133DF6C188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649513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Conector recto 21">
                <a:extLst>
                  <a:ext uri="{FF2B5EF4-FFF2-40B4-BE49-F238E27FC236}">
                    <a16:creationId xmlns:a16="http://schemas.microsoft.com/office/drawing/2014/main" id="{19A39EC1-E3D3-F676-75C7-32340632D8C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0" y="380900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24" name="Conector recto 23">
                <a:extLst>
                  <a:ext uri="{FF2B5EF4-FFF2-40B4-BE49-F238E27FC236}">
                    <a16:creationId xmlns:a16="http://schemas.microsoft.com/office/drawing/2014/main" id="{665D59D2-5E30-C130-8B3D-560E6D0A078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9" y="395593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Conector recto 25">
                <a:extLst>
                  <a:ext uri="{FF2B5EF4-FFF2-40B4-BE49-F238E27FC236}">
                    <a16:creationId xmlns:a16="http://schemas.microsoft.com/office/drawing/2014/main" id="{2DBAE913-8726-4919-0D4F-164BAC8D7D1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7" y="4131389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Conector recto 26">
                <a:extLst>
                  <a:ext uri="{FF2B5EF4-FFF2-40B4-BE49-F238E27FC236}">
                    <a16:creationId xmlns:a16="http://schemas.microsoft.com/office/drawing/2014/main" id="{73122490-A3EF-1CCF-57A2-73126CB81FB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6" y="4345341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16ADC64E-B653-5748-8F85-99419827A74F}"/>
                </a:ext>
              </a:extLst>
            </p:cNvPr>
            <p:cNvSpPr txBox="1"/>
            <p:nvPr/>
          </p:nvSpPr>
          <p:spPr>
            <a:xfrm>
              <a:off x="4476963" y="3219994"/>
              <a:ext cx="532607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82kDa</a:t>
              </a:r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7E5B1FD5-4AF1-8B64-E37E-814844183295}"/>
                </a:ext>
              </a:extLst>
            </p:cNvPr>
            <p:cNvSpPr txBox="1"/>
            <p:nvPr/>
          </p:nvSpPr>
          <p:spPr>
            <a:xfrm>
              <a:off x="4476963" y="3419650"/>
              <a:ext cx="532607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16kDa</a:t>
              </a:r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03FF876E-8C70-EDE0-047E-831FE8D2F68F}"/>
                </a:ext>
              </a:extLst>
            </p:cNvPr>
            <p:cNvSpPr txBox="1"/>
            <p:nvPr/>
          </p:nvSpPr>
          <p:spPr>
            <a:xfrm>
              <a:off x="4525819" y="3559114"/>
              <a:ext cx="470139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82kDa</a:t>
              </a:r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691369C1-1220-FF9C-CECC-883C8C62DF9B}"/>
                </a:ext>
              </a:extLst>
            </p:cNvPr>
            <p:cNvSpPr txBox="1"/>
            <p:nvPr/>
          </p:nvSpPr>
          <p:spPr>
            <a:xfrm>
              <a:off x="4526408" y="3719311"/>
              <a:ext cx="470139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64kDa</a:t>
              </a:r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4B4074FA-5243-54A2-EC82-CC6810F1078D}"/>
                </a:ext>
              </a:extLst>
            </p:cNvPr>
            <p:cNvSpPr txBox="1"/>
            <p:nvPr/>
          </p:nvSpPr>
          <p:spPr>
            <a:xfrm>
              <a:off x="4525817" y="3853888"/>
              <a:ext cx="470139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49kDa</a:t>
              </a:r>
            </a:p>
          </p:txBody>
        </p:sp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DAD07FD7-BCCB-78CA-A0D3-57B576949E63}"/>
                </a:ext>
              </a:extLst>
            </p:cNvPr>
            <p:cNvSpPr txBox="1"/>
            <p:nvPr/>
          </p:nvSpPr>
          <p:spPr>
            <a:xfrm>
              <a:off x="4526408" y="4013871"/>
              <a:ext cx="470139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37kDa</a:t>
              </a:r>
            </a:p>
          </p:txBody>
        </p:sp>
        <p:sp>
          <p:nvSpPr>
            <p:cNvPr id="16" name="CuadroTexto 15">
              <a:extLst>
                <a:ext uri="{FF2B5EF4-FFF2-40B4-BE49-F238E27FC236}">
                  <a16:creationId xmlns:a16="http://schemas.microsoft.com/office/drawing/2014/main" id="{004BF03E-1D72-3441-66DB-949991E03FD6}"/>
                </a:ext>
              </a:extLst>
            </p:cNvPr>
            <p:cNvSpPr txBox="1"/>
            <p:nvPr/>
          </p:nvSpPr>
          <p:spPr>
            <a:xfrm>
              <a:off x="4523309" y="4238744"/>
              <a:ext cx="470139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26kDa</a:t>
              </a:r>
            </a:p>
          </p:txBody>
        </p:sp>
      </p:grpSp>
      <p:sp>
        <p:nvSpPr>
          <p:cNvPr id="29" name="CuadroTexto 28">
            <a:extLst>
              <a:ext uri="{FF2B5EF4-FFF2-40B4-BE49-F238E27FC236}">
                <a16:creationId xmlns:a16="http://schemas.microsoft.com/office/drawing/2014/main" id="{2135E244-1F3B-7BF0-3F61-E9745CC66162}"/>
              </a:ext>
            </a:extLst>
          </p:cNvPr>
          <p:cNvSpPr txBox="1"/>
          <p:nvPr/>
        </p:nvSpPr>
        <p:spPr>
          <a:xfrm>
            <a:off x="3667229" y="1683919"/>
            <a:ext cx="526106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13" dirty="0"/>
              <a:t>NLRP1</a:t>
            </a:r>
          </a:p>
        </p:txBody>
      </p:sp>
      <p:pic>
        <p:nvPicPr>
          <p:cNvPr id="3" name="Imagen 2" descr="Imagen en blanco y negro&#10;&#10;Descripción generada automáticamente con confianza baja">
            <a:extLst>
              <a:ext uri="{FF2B5EF4-FFF2-40B4-BE49-F238E27FC236}">
                <a16:creationId xmlns:a16="http://schemas.microsoft.com/office/drawing/2014/main" id="{42A409BF-BF62-2408-5370-A1AC57EDC83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20" r="22678" b="61372"/>
          <a:stretch/>
        </p:blipFill>
        <p:spPr>
          <a:xfrm>
            <a:off x="1783389" y="1318187"/>
            <a:ext cx="1883841" cy="925117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6" name="Grupo 5">
            <a:extLst>
              <a:ext uri="{FF2B5EF4-FFF2-40B4-BE49-F238E27FC236}">
                <a16:creationId xmlns:a16="http://schemas.microsoft.com/office/drawing/2014/main" id="{80952FC4-A08B-B3D7-D07B-CE6C844A14A9}"/>
              </a:ext>
            </a:extLst>
          </p:cNvPr>
          <p:cNvGrpSpPr/>
          <p:nvPr/>
        </p:nvGrpSpPr>
        <p:grpSpPr>
          <a:xfrm>
            <a:off x="903466" y="1709374"/>
            <a:ext cx="937585" cy="496204"/>
            <a:chOff x="4476963" y="3125466"/>
            <a:chExt cx="794284" cy="729076"/>
          </a:xfrm>
        </p:grpSpPr>
        <p:grpSp>
          <p:nvGrpSpPr>
            <p:cNvPr id="17" name="Grupo 16">
              <a:extLst>
                <a:ext uri="{FF2B5EF4-FFF2-40B4-BE49-F238E27FC236}">
                  <a16:creationId xmlns:a16="http://schemas.microsoft.com/office/drawing/2014/main" id="{6455B4FE-16A5-904F-4250-A5C54999BF2A}"/>
                </a:ext>
              </a:extLst>
            </p:cNvPr>
            <p:cNvGrpSpPr/>
            <p:nvPr/>
          </p:nvGrpSpPr>
          <p:grpSpPr>
            <a:xfrm>
              <a:off x="4999650" y="3310666"/>
              <a:ext cx="271597" cy="498338"/>
              <a:chOff x="4999650" y="3310666"/>
              <a:chExt cx="271597" cy="498338"/>
            </a:xfrm>
          </p:grpSpPr>
          <p:cxnSp>
            <p:nvCxnSpPr>
              <p:cNvPr id="37" name="Conector recto 36">
                <a:extLst>
                  <a:ext uri="{FF2B5EF4-FFF2-40B4-BE49-F238E27FC236}">
                    <a16:creationId xmlns:a16="http://schemas.microsoft.com/office/drawing/2014/main" id="{DF18E5A8-3C20-F91C-9330-3CA751B7F91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2" y="3310666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Conector recto 37">
                <a:extLst>
                  <a:ext uri="{FF2B5EF4-FFF2-40B4-BE49-F238E27FC236}">
                    <a16:creationId xmlns:a16="http://schemas.microsoft.com/office/drawing/2014/main" id="{F12B26A2-6E5B-FA81-00BD-C1F290B8598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483646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Conector recto 38">
                <a:extLst>
                  <a:ext uri="{FF2B5EF4-FFF2-40B4-BE49-F238E27FC236}">
                    <a16:creationId xmlns:a16="http://schemas.microsoft.com/office/drawing/2014/main" id="{259E7E14-5B40-8674-882B-2222280D664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649513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Conector recto 39">
                <a:extLst>
                  <a:ext uri="{FF2B5EF4-FFF2-40B4-BE49-F238E27FC236}">
                    <a16:creationId xmlns:a16="http://schemas.microsoft.com/office/drawing/2014/main" id="{05F33000-8D74-1AD7-6444-941A53DB300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0" y="380900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</p:grp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61D6E092-9B1B-66F5-E077-9BEB59D9A1C9}"/>
                </a:ext>
              </a:extLst>
            </p:cNvPr>
            <p:cNvSpPr txBox="1"/>
            <p:nvPr/>
          </p:nvSpPr>
          <p:spPr>
            <a:xfrm>
              <a:off x="4476963" y="3125466"/>
              <a:ext cx="532608" cy="3900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82kDa</a:t>
              </a:r>
            </a:p>
          </p:txBody>
        </p: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BB07BF14-FBBC-39F2-C4C8-BD48E3FD1C37}"/>
                </a:ext>
              </a:extLst>
            </p:cNvPr>
            <p:cNvSpPr txBox="1"/>
            <p:nvPr/>
          </p:nvSpPr>
          <p:spPr>
            <a:xfrm>
              <a:off x="4483997" y="3297983"/>
              <a:ext cx="532607" cy="3900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16kDa</a:t>
              </a:r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1C53B108-3DE7-4A98-D5C7-5CB2540F6AF5}"/>
                </a:ext>
              </a:extLst>
            </p:cNvPr>
            <p:cNvSpPr txBox="1"/>
            <p:nvPr/>
          </p:nvSpPr>
          <p:spPr>
            <a:xfrm>
              <a:off x="4546463" y="3464504"/>
              <a:ext cx="470140" cy="3900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82kDa</a:t>
              </a:r>
            </a:p>
          </p:txBody>
        </p:sp>
      </p:grpSp>
      <p:sp>
        <p:nvSpPr>
          <p:cNvPr id="30" name="Rectángulo 29">
            <a:extLst>
              <a:ext uri="{FF2B5EF4-FFF2-40B4-BE49-F238E27FC236}">
                <a16:creationId xmlns:a16="http://schemas.microsoft.com/office/drawing/2014/main" id="{E74161A8-0EA0-0E29-6DB3-12E4B8BA11B5}"/>
              </a:ext>
            </a:extLst>
          </p:cNvPr>
          <p:cNvSpPr/>
          <p:nvPr/>
        </p:nvSpPr>
        <p:spPr>
          <a:xfrm>
            <a:off x="2027143" y="1815340"/>
            <a:ext cx="761786" cy="1982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013"/>
          </a:p>
        </p:txBody>
      </p:sp>
      <p:sp>
        <p:nvSpPr>
          <p:cNvPr id="44" name="CuadroTexto 43">
            <a:extLst>
              <a:ext uri="{FF2B5EF4-FFF2-40B4-BE49-F238E27FC236}">
                <a16:creationId xmlns:a16="http://schemas.microsoft.com/office/drawing/2014/main" id="{E7F871D1-DD2C-1CDC-89C0-9E1267696010}"/>
              </a:ext>
            </a:extLst>
          </p:cNvPr>
          <p:cNvSpPr txBox="1"/>
          <p:nvPr/>
        </p:nvSpPr>
        <p:spPr>
          <a:xfrm>
            <a:off x="985507" y="2044674"/>
            <a:ext cx="554960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_tradnl" sz="1125" dirty="0"/>
              <a:t>64kDa</a:t>
            </a:r>
          </a:p>
        </p:txBody>
      </p:sp>
      <p:grpSp>
        <p:nvGrpSpPr>
          <p:cNvPr id="55" name="Grupo 54">
            <a:extLst>
              <a:ext uri="{FF2B5EF4-FFF2-40B4-BE49-F238E27FC236}">
                <a16:creationId xmlns:a16="http://schemas.microsoft.com/office/drawing/2014/main" id="{310D0092-15C0-5BAC-78B3-2FF9B3258CF6}"/>
              </a:ext>
            </a:extLst>
          </p:cNvPr>
          <p:cNvGrpSpPr/>
          <p:nvPr/>
        </p:nvGrpSpPr>
        <p:grpSpPr>
          <a:xfrm>
            <a:off x="1184275" y="905155"/>
            <a:ext cx="1710605" cy="474423"/>
            <a:chOff x="267081" y="281922"/>
            <a:chExt cx="3837877" cy="843418"/>
          </a:xfrm>
        </p:grpSpPr>
        <p:sp>
          <p:nvSpPr>
            <p:cNvPr id="45" name="CuadroTexto 44">
              <a:extLst>
                <a:ext uri="{FF2B5EF4-FFF2-40B4-BE49-F238E27FC236}">
                  <a16:creationId xmlns:a16="http://schemas.microsoft.com/office/drawing/2014/main" id="{98AE03D9-FDF9-A915-BF73-D611CF569C40}"/>
                </a:ext>
              </a:extLst>
            </p:cNvPr>
            <p:cNvSpPr txBox="1"/>
            <p:nvPr/>
          </p:nvSpPr>
          <p:spPr>
            <a:xfrm>
              <a:off x="267081" y="684080"/>
              <a:ext cx="1593953" cy="441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013" b="1" dirty="0" err="1">
                  <a:latin typeface="Arial" charset="0"/>
                  <a:ea typeface="Arial" charset="0"/>
                  <a:cs typeface="Arial" charset="0"/>
                </a:rPr>
                <a:t>Nilotinib</a:t>
              </a:r>
              <a:endParaRPr lang="es-ES_tradnl" sz="1013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6" name="CuadroTexto 45">
              <a:extLst>
                <a:ext uri="{FF2B5EF4-FFF2-40B4-BE49-F238E27FC236}">
                  <a16:creationId xmlns:a16="http://schemas.microsoft.com/office/drawing/2014/main" id="{58B01AA3-91AC-F63F-F050-653F649E7EA1}"/>
                </a:ext>
              </a:extLst>
            </p:cNvPr>
            <p:cNvSpPr txBox="1"/>
            <p:nvPr/>
          </p:nvSpPr>
          <p:spPr>
            <a:xfrm>
              <a:off x="539790" y="295223"/>
              <a:ext cx="1392551" cy="441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013" b="1" dirty="0" err="1">
                  <a:latin typeface="Arial" charset="0"/>
                  <a:ea typeface="Arial" charset="0"/>
                  <a:cs typeface="Arial" charset="0"/>
                </a:rPr>
                <a:t>Hemin</a:t>
              </a:r>
              <a:r>
                <a:rPr lang="es-ES_tradnl" sz="1013" b="1" dirty="0">
                  <a:latin typeface="Arial" charset="0"/>
                  <a:ea typeface="Arial" charset="0"/>
                  <a:cs typeface="Arial" charset="0"/>
                </a:rPr>
                <a:t> </a:t>
              </a:r>
            </a:p>
          </p:txBody>
        </p:sp>
        <p:sp>
          <p:nvSpPr>
            <p:cNvPr id="47" name="CuadroTexto 46">
              <a:extLst>
                <a:ext uri="{FF2B5EF4-FFF2-40B4-BE49-F238E27FC236}">
                  <a16:creationId xmlns:a16="http://schemas.microsoft.com/office/drawing/2014/main" id="{4B22347D-0C44-ECC2-4A87-5A947201C2B5}"/>
                </a:ext>
              </a:extLst>
            </p:cNvPr>
            <p:cNvSpPr txBox="1"/>
            <p:nvPr/>
          </p:nvSpPr>
          <p:spPr>
            <a:xfrm>
              <a:off x="2611798" y="672334"/>
              <a:ext cx="583348" cy="441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13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48" name="CuadroTexto 47">
              <a:extLst>
                <a:ext uri="{FF2B5EF4-FFF2-40B4-BE49-F238E27FC236}">
                  <a16:creationId xmlns:a16="http://schemas.microsoft.com/office/drawing/2014/main" id="{4646C71E-F31D-136E-1727-1EE0F1C6FDD0}"/>
                </a:ext>
              </a:extLst>
            </p:cNvPr>
            <p:cNvSpPr txBox="1"/>
            <p:nvPr/>
          </p:nvSpPr>
          <p:spPr>
            <a:xfrm>
              <a:off x="3521610" y="672078"/>
              <a:ext cx="583348" cy="441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13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49" name="CuadroTexto 48">
              <a:extLst>
                <a:ext uri="{FF2B5EF4-FFF2-40B4-BE49-F238E27FC236}">
                  <a16:creationId xmlns:a16="http://schemas.microsoft.com/office/drawing/2014/main" id="{93A62BB7-F385-F9A6-002D-A1A15CD2E919}"/>
                </a:ext>
              </a:extLst>
            </p:cNvPr>
            <p:cNvSpPr txBox="1"/>
            <p:nvPr/>
          </p:nvSpPr>
          <p:spPr>
            <a:xfrm>
              <a:off x="3090955" y="652453"/>
              <a:ext cx="511419" cy="441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13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50" name="CuadroTexto 49">
              <a:extLst>
                <a:ext uri="{FF2B5EF4-FFF2-40B4-BE49-F238E27FC236}">
                  <a16:creationId xmlns:a16="http://schemas.microsoft.com/office/drawing/2014/main" id="{142547B8-3FED-FBBB-A1C1-B24ECB545C35}"/>
                </a:ext>
              </a:extLst>
            </p:cNvPr>
            <p:cNvSpPr txBox="1"/>
            <p:nvPr/>
          </p:nvSpPr>
          <p:spPr>
            <a:xfrm>
              <a:off x="2159567" y="655451"/>
              <a:ext cx="511419" cy="441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13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51" name="CuadroTexto 50">
              <a:extLst>
                <a:ext uri="{FF2B5EF4-FFF2-40B4-BE49-F238E27FC236}">
                  <a16:creationId xmlns:a16="http://schemas.microsoft.com/office/drawing/2014/main" id="{2AE99E3E-5EA5-28B4-990D-C6FE82C6D11A}"/>
                </a:ext>
              </a:extLst>
            </p:cNvPr>
            <p:cNvSpPr txBox="1"/>
            <p:nvPr/>
          </p:nvSpPr>
          <p:spPr>
            <a:xfrm>
              <a:off x="2159564" y="282846"/>
              <a:ext cx="511419" cy="441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13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52" name="CuadroTexto 51">
              <a:extLst>
                <a:ext uri="{FF2B5EF4-FFF2-40B4-BE49-F238E27FC236}">
                  <a16:creationId xmlns:a16="http://schemas.microsoft.com/office/drawing/2014/main" id="{71EE4F11-A1E8-6C82-6CA4-0D2C993E6536}"/>
                </a:ext>
              </a:extLst>
            </p:cNvPr>
            <p:cNvSpPr txBox="1"/>
            <p:nvPr/>
          </p:nvSpPr>
          <p:spPr>
            <a:xfrm>
              <a:off x="2617997" y="281922"/>
              <a:ext cx="511419" cy="441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13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53" name="CuadroTexto 52">
              <a:extLst>
                <a:ext uri="{FF2B5EF4-FFF2-40B4-BE49-F238E27FC236}">
                  <a16:creationId xmlns:a16="http://schemas.microsoft.com/office/drawing/2014/main" id="{51F8C930-0D7A-9854-EF3B-6B87716D26BA}"/>
                </a:ext>
              </a:extLst>
            </p:cNvPr>
            <p:cNvSpPr txBox="1"/>
            <p:nvPr/>
          </p:nvSpPr>
          <p:spPr>
            <a:xfrm>
              <a:off x="3052168" y="307316"/>
              <a:ext cx="583348" cy="441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13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54" name="CuadroTexto 53">
              <a:extLst>
                <a:ext uri="{FF2B5EF4-FFF2-40B4-BE49-F238E27FC236}">
                  <a16:creationId xmlns:a16="http://schemas.microsoft.com/office/drawing/2014/main" id="{54E3A0E3-A904-3548-6384-7A687C9BCA42}"/>
                </a:ext>
              </a:extLst>
            </p:cNvPr>
            <p:cNvSpPr txBox="1"/>
            <p:nvPr/>
          </p:nvSpPr>
          <p:spPr>
            <a:xfrm>
              <a:off x="3521610" y="305767"/>
              <a:ext cx="583348" cy="441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13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</p:grpSp>
      <p:sp>
        <p:nvSpPr>
          <p:cNvPr id="58" name="Rectángulo 57">
            <a:extLst>
              <a:ext uri="{FF2B5EF4-FFF2-40B4-BE49-F238E27FC236}">
                <a16:creationId xmlns:a16="http://schemas.microsoft.com/office/drawing/2014/main" id="{43A1FED4-B30E-3905-0EF1-17DA44FC7FB8}"/>
              </a:ext>
            </a:extLst>
          </p:cNvPr>
          <p:cNvSpPr/>
          <p:nvPr/>
        </p:nvSpPr>
        <p:spPr>
          <a:xfrm>
            <a:off x="1985022" y="3238084"/>
            <a:ext cx="761786" cy="1982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013"/>
          </a:p>
        </p:txBody>
      </p:sp>
      <p:sp>
        <p:nvSpPr>
          <p:cNvPr id="59" name="CuadroTexto 58">
            <a:extLst>
              <a:ext uri="{FF2B5EF4-FFF2-40B4-BE49-F238E27FC236}">
                <a16:creationId xmlns:a16="http://schemas.microsoft.com/office/drawing/2014/main" id="{A473DF37-5308-B1AF-C511-0D15B7EE8B94}"/>
              </a:ext>
            </a:extLst>
          </p:cNvPr>
          <p:cNvSpPr txBox="1"/>
          <p:nvPr/>
        </p:nvSpPr>
        <p:spPr>
          <a:xfrm>
            <a:off x="3685320" y="3041103"/>
            <a:ext cx="461986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13" dirty="0"/>
              <a:t>ACTB</a:t>
            </a:r>
          </a:p>
        </p:txBody>
      </p:sp>
      <p:pic>
        <p:nvPicPr>
          <p:cNvPr id="62" name="Imagen 61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F2141D81-4FA9-8618-E836-00E38748E7E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246" r="41077" b="13814"/>
          <a:stretch/>
        </p:blipFill>
        <p:spPr>
          <a:xfrm>
            <a:off x="1625479" y="3977652"/>
            <a:ext cx="1894200" cy="1651075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63" name="Grupo 62">
            <a:extLst>
              <a:ext uri="{FF2B5EF4-FFF2-40B4-BE49-F238E27FC236}">
                <a16:creationId xmlns:a16="http://schemas.microsoft.com/office/drawing/2014/main" id="{B51C5646-7A41-6ABE-0BD8-D3D0365DF8F3}"/>
              </a:ext>
            </a:extLst>
          </p:cNvPr>
          <p:cNvGrpSpPr/>
          <p:nvPr/>
        </p:nvGrpSpPr>
        <p:grpSpPr>
          <a:xfrm>
            <a:off x="734115" y="4205589"/>
            <a:ext cx="937586" cy="1148398"/>
            <a:chOff x="4476963" y="3170363"/>
            <a:chExt cx="794284" cy="1353267"/>
          </a:xfrm>
        </p:grpSpPr>
        <p:grpSp>
          <p:nvGrpSpPr>
            <p:cNvPr id="64" name="Grupo 63">
              <a:extLst>
                <a:ext uri="{FF2B5EF4-FFF2-40B4-BE49-F238E27FC236}">
                  <a16:creationId xmlns:a16="http://schemas.microsoft.com/office/drawing/2014/main" id="{1075AE8B-341E-AFAD-D913-A6A8B22A5847}"/>
                </a:ext>
              </a:extLst>
            </p:cNvPr>
            <p:cNvGrpSpPr/>
            <p:nvPr/>
          </p:nvGrpSpPr>
          <p:grpSpPr>
            <a:xfrm>
              <a:off x="4999646" y="3302364"/>
              <a:ext cx="271601" cy="1015050"/>
              <a:chOff x="4999646" y="3302364"/>
              <a:chExt cx="271601" cy="1015050"/>
            </a:xfrm>
          </p:grpSpPr>
          <p:cxnSp>
            <p:nvCxnSpPr>
              <p:cNvPr id="72" name="Conector recto 71">
                <a:extLst>
                  <a:ext uri="{FF2B5EF4-FFF2-40B4-BE49-F238E27FC236}">
                    <a16:creationId xmlns:a16="http://schemas.microsoft.com/office/drawing/2014/main" id="{9062BE9B-9E10-D835-FA50-B05DA551B59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2" y="330236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Conector recto 72">
                <a:extLst>
                  <a:ext uri="{FF2B5EF4-FFF2-40B4-BE49-F238E27FC236}">
                    <a16:creationId xmlns:a16="http://schemas.microsoft.com/office/drawing/2014/main" id="{180CFFF9-77ED-F079-90C7-33E207643A5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396889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Conector recto 73">
                <a:extLst>
                  <a:ext uri="{FF2B5EF4-FFF2-40B4-BE49-F238E27FC236}">
                    <a16:creationId xmlns:a16="http://schemas.microsoft.com/office/drawing/2014/main" id="{63941729-08C1-D7C8-88D7-E976BF5EA16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508365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Conector recto 74">
                <a:extLst>
                  <a:ext uri="{FF2B5EF4-FFF2-40B4-BE49-F238E27FC236}">
                    <a16:creationId xmlns:a16="http://schemas.microsoft.com/office/drawing/2014/main" id="{B6A8A7B0-86FE-E44E-B623-15AD9865DC6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0" y="3626341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76" name="Conector recto 75">
                <a:extLst>
                  <a:ext uri="{FF2B5EF4-FFF2-40B4-BE49-F238E27FC236}">
                    <a16:creationId xmlns:a16="http://schemas.microsoft.com/office/drawing/2014/main" id="{3492D2D1-34BB-14BF-E35A-1D4C2630813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9" y="3798182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Conector recto 76">
                <a:extLst>
                  <a:ext uri="{FF2B5EF4-FFF2-40B4-BE49-F238E27FC236}">
                    <a16:creationId xmlns:a16="http://schemas.microsoft.com/office/drawing/2014/main" id="{6B68C81B-783E-A086-A5F7-C0B112D558B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7" y="397363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Conector recto 77">
                <a:extLst>
                  <a:ext uri="{FF2B5EF4-FFF2-40B4-BE49-F238E27FC236}">
                    <a16:creationId xmlns:a16="http://schemas.microsoft.com/office/drawing/2014/main" id="{0D5D2EB7-6300-07EC-5D1C-A6EC8543363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6" y="431741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5" name="CuadroTexto 64">
              <a:extLst>
                <a:ext uri="{FF2B5EF4-FFF2-40B4-BE49-F238E27FC236}">
                  <a16:creationId xmlns:a16="http://schemas.microsoft.com/office/drawing/2014/main" id="{264484C2-2B45-D946-F22F-2C34231B1762}"/>
                </a:ext>
              </a:extLst>
            </p:cNvPr>
            <p:cNvSpPr txBox="1"/>
            <p:nvPr/>
          </p:nvSpPr>
          <p:spPr>
            <a:xfrm>
              <a:off x="4476963" y="3170363"/>
              <a:ext cx="532607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82kDa</a:t>
              </a:r>
            </a:p>
          </p:txBody>
        </p:sp>
        <p:sp>
          <p:nvSpPr>
            <p:cNvPr id="66" name="CuadroTexto 65">
              <a:extLst>
                <a:ext uri="{FF2B5EF4-FFF2-40B4-BE49-F238E27FC236}">
                  <a16:creationId xmlns:a16="http://schemas.microsoft.com/office/drawing/2014/main" id="{BD0FAB52-B17A-8882-61F6-79F727941CDD}"/>
                </a:ext>
              </a:extLst>
            </p:cNvPr>
            <p:cNvSpPr txBox="1"/>
            <p:nvPr/>
          </p:nvSpPr>
          <p:spPr>
            <a:xfrm>
              <a:off x="4476963" y="3254565"/>
              <a:ext cx="532607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16kDa</a:t>
              </a:r>
            </a:p>
          </p:txBody>
        </p:sp>
        <p:sp>
          <p:nvSpPr>
            <p:cNvPr id="67" name="CuadroTexto 66">
              <a:extLst>
                <a:ext uri="{FF2B5EF4-FFF2-40B4-BE49-F238E27FC236}">
                  <a16:creationId xmlns:a16="http://schemas.microsoft.com/office/drawing/2014/main" id="{422FDD0B-58C7-4479-0D00-95C4EF43A919}"/>
                </a:ext>
              </a:extLst>
            </p:cNvPr>
            <p:cNvSpPr txBox="1"/>
            <p:nvPr/>
          </p:nvSpPr>
          <p:spPr>
            <a:xfrm>
              <a:off x="4529507" y="3376091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82kDa</a:t>
              </a:r>
            </a:p>
          </p:txBody>
        </p:sp>
        <p:sp>
          <p:nvSpPr>
            <p:cNvPr id="68" name="CuadroTexto 67">
              <a:extLst>
                <a:ext uri="{FF2B5EF4-FFF2-40B4-BE49-F238E27FC236}">
                  <a16:creationId xmlns:a16="http://schemas.microsoft.com/office/drawing/2014/main" id="{E95384B0-D4F4-3A37-E705-0174266AE06C}"/>
                </a:ext>
              </a:extLst>
            </p:cNvPr>
            <p:cNvSpPr txBox="1"/>
            <p:nvPr/>
          </p:nvSpPr>
          <p:spPr>
            <a:xfrm>
              <a:off x="4526408" y="3495134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64kDa</a:t>
              </a:r>
            </a:p>
          </p:txBody>
        </p:sp>
        <p:sp>
          <p:nvSpPr>
            <p:cNvPr id="69" name="CuadroTexto 68">
              <a:extLst>
                <a:ext uri="{FF2B5EF4-FFF2-40B4-BE49-F238E27FC236}">
                  <a16:creationId xmlns:a16="http://schemas.microsoft.com/office/drawing/2014/main" id="{AAC3DCE8-3FCF-C02C-D2CA-3AB16CC97201}"/>
                </a:ext>
              </a:extLst>
            </p:cNvPr>
            <p:cNvSpPr txBox="1"/>
            <p:nvPr/>
          </p:nvSpPr>
          <p:spPr>
            <a:xfrm>
              <a:off x="4525817" y="3696136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49kDa</a:t>
              </a:r>
            </a:p>
          </p:txBody>
        </p:sp>
        <p:sp>
          <p:nvSpPr>
            <p:cNvPr id="70" name="CuadroTexto 69">
              <a:extLst>
                <a:ext uri="{FF2B5EF4-FFF2-40B4-BE49-F238E27FC236}">
                  <a16:creationId xmlns:a16="http://schemas.microsoft.com/office/drawing/2014/main" id="{A6BEE17A-6AC2-1FFA-2986-9F214E1B461D}"/>
                </a:ext>
              </a:extLst>
            </p:cNvPr>
            <p:cNvSpPr txBox="1"/>
            <p:nvPr/>
          </p:nvSpPr>
          <p:spPr>
            <a:xfrm>
              <a:off x="4526408" y="3856115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37kDa</a:t>
              </a:r>
            </a:p>
          </p:txBody>
        </p:sp>
        <p:sp>
          <p:nvSpPr>
            <p:cNvPr id="71" name="CuadroTexto 70">
              <a:extLst>
                <a:ext uri="{FF2B5EF4-FFF2-40B4-BE49-F238E27FC236}">
                  <a16:creationId xmlns:a16="http://schemas.microsoft.com/office/drawing/2014/main" id="{91FA0395-1622-D6EE-6203-A3EFA130F284}"/>
                </a:ext>
              </a:extLst>
            </p:cNvPr>
            <p:cNvSpPr txBox="1"/>
            <p:nvPr/>
          </p:nvSpPr>
          <p:spPr>
            <a:xfrm>
              <a:off x="4523309" y="4210817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26kDa</a:t>
              </a:r>
            </a:p>
          </p:txBody>
        </p:sp>
      </p:grpSp>
      <p:sp>
        <p:nvSpPr>
          <p:cNvPr id="79" name="Rectángulo 78">
            <a:extLst>
              <a:ext uri="{FF2B5EF4-FFF2-40B4-BE49-F238E27FC236}">
                <a16:creationId xmlns:a16="http://schemas.microsoft.com/office/drawing/2014/main" id="{A9EBDE9A-BBBC-92B4-5028-2898417ACC40}"/>
              </a:ext>
            </a:extLst>
          </p:cNvPr>
          <p:cNvSpPr/>
          <p:nvPr/>
        </p:nvSpPr>
        <p:spPr>
          <a:xfrm>
            <a:off x="1934363" y="4673105"/>
            <a:ext cx="878140" cy="160945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013"/>
          </a:p>
        </p:txBody>
      </p:sp>
      <p:pic>
        <p:nvPicPr>
          <p:cNvPr id="94" name="Imagen 93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430E5B00-1908-D489-1059-7458EC9A0E1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63" t="11935" r="18680" b="2648"/>
          <a:stretch/>
        </p:blipFill>
        <p:spPr>
          <a:xfrm>
            <a:off x="1680750" y="5774068"/>
            <a:ext cx="2004569" cy="2045672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95" name="Grupo 94">
            <a:extLst>
              <a:ext uri="{FF2B5EF4-FFF2-40B4-BE49-F238E27FC236}">
                <a16:creationId xmlns:a16="http://schemas.microsoft.com/office/drawing/2014/main" id="{9A88576D-03BD-A42B-E63C-E85294663A8C}"/>
              </a:ext>
            </a:extLst>
          </p:cNvPr>
          <p:cNvGrpSpPr/>
          <p:nvPr/>
        </p:nvGrpSpPr>
        <p:grpSpPr>
          <a:xfrm>
            <a:off x="715482" y="5985838"/>
            <a:ext cx="937586" cy="1148398"/>
            <a:chOff x="4476963" y="3170363"/>
            <a:chExt cx="794284" cy="1353267"/>
          </a:xfrm>
        </p:grpSpPr>
        <p:grpSp>
          <p:nvGrpSpPr>
            <p:cNvPr id="96" name="Grupo 95">
              <a:extLst>
                <a:ext uri="{FF2B5EF4-FFF2-40B4-BE49-F238E27FC236}">
                  <a16:creationId xmlns:a16="http://schemas.microsoft.com/office/drawing/2014/main" id="{4B3DF87F-D8DD-2DA7-B47B-6D34F3CDBB29}"/>
                </a:ext>
              </a:extLst>
            </p:cNvPr>
            <p:cNvGrpSpPr/>
            <p:nvPr/>
          </p:nvGrpSpPr>
          <p:grpSpPr>
            <a:xfrm>
              <a:off x="4999646" y="3302364"/>
              <a:ext cx="271601" cy="1015050"/>
              <a:chOff x="4999646" y="3302364"/>
              <a:chExt cx="271601" cy="1015050"/>
            </a:xfrm>
          </p:grpSpPr>
          <p:cxnSp>
            <p:nvCxnSpPr>
              <p:cNvPr id="104" name="Conector recto 103">
                <a:extLst>
                  <a:ext uri="{FF2B5EF4-FFF2-40B4-BE49-F238E27FC236}">
                    <a16:creationId xmlns:a16="http://schemas.microsoft.com/office/drawing/2014/main" id="{40D41830-67CB-3C72-52FD-467D42572DE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2" y="330236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Conector recto 104">
                <a:extLst>
                  <a:ext uri="{FF2B5EF4-FFF2-40B4-BE49-F238E27FC236}">
                    <a16:creationId xmlns:a16="http://schemas.microsoft.com/office/drawing/2014/main" id="{2A94A489-27E5-AD34-A159-B35D12E68C1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396889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Conector recto 105">
                <a:extLst>
                  <a:ext uri="{FF2B5EF4-FFF2-40B4-BE49-F238E27FC236}">
                    <a16:creationId xmlns:a16="http://schemas.microsoft.com/office/drawing/2014/main" id="{8F41F395-110D-4CAB-A530-99D069A3384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508365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Conector recto 106">
                <a:extLst>
                  <a:ext uri="{FF2B5EF4-FFF2-40B4-BE49-F238E27FC236}">
                    <a16:creationId xmlns:a16="http://schemas.microsoft.com/office/drawing/2014/main" id="{996EB4DB-030B-B199-ED06-B064270EA2C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0" y="3626341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08" name="Conector recto 107">
                <a:extLst>
                  <a:ext uri="{FF2B5EF4-FFF2-40B4-BE49-F238E27FC236}">
                    <a16:creationId xmlns:a16="http://schemas.microsoft.com/office/drawing/2014/main" id="{53C76150-5999-E5A9-80AD-9A6205CFEE7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9" y="3798182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Conector recto 108">
                <a:extLst>
                  <a:ext uri="{FF2B5EF4-FFF2-40B4-BE49-F238E27FC236}">
                    <a16:creationId xmlns:a16="http://schemas.microsoft.com/office/drawing/2014/main" id="{1F475A3C-C14D-01BE-0BCE-524EE951391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7" y="397363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Conector recto 109">
                <a:extLst>
                  <a:ext uri="{FF2B5EF4-FFF2-40B4-BE49-F238E27FC236}">
                    <a16:creationId xmlns:a16="http://schemas.microsoft.com/office/drawing/2014/main" id="{CD607DE3-1F26-4AB7-1A61-51F5BB60ABC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6" y="431741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7" name="CuadroTexto 96">
              <a:extLst>
                <a:ext uri="{FF2B5EF4-FFF2-40B4-BE49-F238E27FC236}">
                  <a16:creationId xmlns:a16="http://schemas.microsoft.com/office/drawing/2014/main" id="{35494226-F88F-EB79-62C1-F164BC2B2A0A}"/>
                </a:ext>
              </a:extLst>
            </p:cNvPr>
            <p:cNvSpPr txBox="1"/>
            <p:nvPr/>
          </p:nvSpPr>
          <p:spPr>
            <a:xfrm>
              <a:off x="4476963" y="3170363"/>
              <a:ext cx="532607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82kDa</a:t>
              </a:r>
            </a:p>
          </p:txBody>
        </p:sp>
        <p:sp>
          <p:nvSpPr>
            <p:cNvPr id="98" name="CuadroTexto 97">
              <a:extLst>
                <a:ext uri="{FF2B5EF4-FFF2-40B4-BE49-F238E27FC236}">
                  <a16:creationId xmlns:a16="http://schemas.microsoft.com/office/drawing/2014/main" id="{BE3B2D01-FE87-52B5-FF92-4ACACF3D3C3E}"/>
                </a:ext>
              </a:extLst>
            </p:cNvPr>
            <p:cNvSpPr txBox="1"/>
            <p:nvPr/>
          </p:nvSpPr>
          <p:spPr>
            <a:xfrm>
              <a:off x="4476963" y="3254565"/>
              <a:ext cx="532607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16kDa</a:t>
              </a:r>
            </a:p>
          </p:txBody>
        </p:sp>
        <p:sp>
          <p:nvSpPr>
            <p:cNvPr id="99" name="CuadroTexto 98">
              <a:extLst>
                <a:ext uri="{FF2B5EF4-FFF2-40B4-BE49-F238E27FC236}">
                  <a16:creationId xmlns:a16="http://schemas.microsoft.com/office/drawing/2014/main" id="{C856674C-8346-A320-1D81-4515FC19ACCD}"/>
                </a:ext>
              </a:extLst>
            </p:cNvPr>
            <p:cNvSpPr txBox="1"/>
            <p:nvPr/>
          </p:nvSpPr>
          <p:spPr>
            <a:xfrm>
              <a:off x="4529507" y="3376091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82kDa</a:t>
              </a:r>
            </a:p>
          </p:txBody>
        </p:sp>
        <p:sp>
          <p:nvSpPr>
            <p:cNvPr id="100" name="CuadroTexto 99">
              <a:extLst>
                <a:ext uri="{FF2B5EF4-FFF2-40B4-BE49-F238E27FC236}">
                  <a16:creationId xmlns:a16="http://schemas.microsoft.com/office/drawing/2014/main" id="{D17C37FB-3A21-317D-90A7-838E6E866E55}"/>
                </a:ext>
              </a:extLst>
            </p:cNvPr>
            <p:cNvSpPr txBox="1"/>
            <p:nvPr/>
          </p:nvSpPr>
          <p:spPr>
            <a:xfrm>
              <a:off x="4526408" y="3495134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64kDa</a:t>
              </a:r>
            </a:p>
          </p:txBody>
        </p:sp>
        <p:sp>
          <p:nvSpPr>
            <p:cNvPr id="101" name="CuadroTexto 100">
              <a:extLst>
                <a:ext uri="{FF2B5EF4-FFF2-40B4-BE49-F238E27FC236}">
                  <a16:creationId xmlns:a16="http://schemas.microsoft.com/office/drawing/2014/main" id="{59F67548-5A65-5136-6217-E9D2F25207BE}"/>
                </a:ext>
              </a:extLst>
            </p:cNvPr>
            <p:cNvSpPr txBox="1"/>
            <p:nvPr/>
          </p:nvSpPr>
          <p:spPr>
            <a:xfrm>
              <a:off x="4525817" y="3696136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49kDa</a:t>
              </a:r>
            </a:p>
          </p:txBody>
        </p:sp>
        <p:sp>
          <p:nvSpPr>
            <p:cNvPr id="102" name="CuadroTexto 101">
              <a:extLst>
                <a:ext uri="{FF2B5EF4-FFF2-40B4-BE49-F238E27FC236}">
                  <a16:creationId xmlns:a16="http://schemas.microsoft.com/office/drawing/2014/main" id="{887B108D-B102-96CD-32F0-192E66B9CE55}"/>
                </a:ext>
              </a:extLst>
            </p:cNvPr>
            <p:cNvSpPr txBox="1"/>
            <p:nvPr/>
          </p:nvSpPr>
          <p:spPr>
            <a:xfrm>
              <a:off x="4526408" y="3856115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37kDa</a:t>
              </a:r>
            </a:p>
          </p:txBody>
        </p:sp>
        <p:sp>
          <p:nvSpPr>
            <p:cNvPr id="103" name="CuadroTexto 102">
              <a:extLst>
                <a:ext uri="{FF2B5EF4-FFF2-40B4-BE49-F238E27FC236}">
                  <a16:creationId xmlns:a16="http://schemas.microsoft.com/office/drawing/2014/main" id="{F2CA8EB3-90D8-E3CA-DF1D-24CB13506E39}"/>
                </a:ext>
              </a:extLst>
            </p:cNvPr>
            <p:cNvSpPr txBox="1"/>
            <p:nvPr/>
          </p:nvSpPr>
          <p:spPr>
            <a:xfrm>
              <a:off x="4523309" y="4210817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26kDa</a:t>
              </a:r>
            </a:p>
          </p:txBody>
        </p:sp>
      </p:grpSp>
      <p:sp>
        <p:nvSpPr>
          <p:cNvPr id="111" name="Rectángulo 110">
            <a:extLst>
              <a:ext uri="{FF2B5EF4-FFF2-40B4-BE49-F238E27FC236}">
                <a16:creationId xmlns:a16="http://schemas.microsoft.com/office/drawing/2014/main" id="{639D055B-F362-C4D7-03B5-C623AAFF4CA5}"/>
              </a:ext>
            </a:extLst>
          </p:cNvPr>
          <p:cNvSpPr/>
          <p:nvPr/>
        </p:nvSpPr>
        <p:spPr>
          <a:xfrm>
            <a:off x="1894726" y="6564743"/>
            <a:ext cx="878140" cy="160945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013"/>
          </a:p>
        </p:txBody>
      </p:sp>
      <p:sp>
        <p:nvSpPr>
          <p:cNvPr id="112" name="CuadroTexto 111">
            <a:extLst>
              <a:ext uri="{FF2B5EF4-FFF2-40B4-BE49-F238E27FC236}">
                <a16:creationId xmlns:a16="http://schemas.microsoft.com/office/drawing/2014/main" id="{17DE7CD4-CEF5-1A3C-4405-DC9E90863427}"/>
              </a:ext>
            </a:extLst>
          </p:cNvPr>
          <p:cNvSpPr txBox="1"/>
          <p:nvPr/>
        </p:nvSpPr>
        <p:spPr>
          <a:xfrm>
            <a:off x="3635710" y="4463205"/>
            <a:ext cx="54534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13" dirty="0"/>
              <a:t>GATA1</a:t>
            </a:r>
          </a:p>
        </p:txBody>
      </p:sp>
      <p:sp>
        <p:nvSpPr>
          <p:cNvPr id="113" name="CuadroTexto 112">
            <a:extLst>
              <a:ext uri="{FF2B5EF4-FFF2-40B4-BE49-F238E27FC236}">
                <a16:creationId xmlns:a16="http://schemas.microsoft.com/office/drawing/2014/main" id="{B9F64BC0-143F-F0DC-D338-6209797FBA4D}"/>
              </a:ext>
            </a:extLst>
          </p:cNvPr>
          <p:cNvSpPr txBox="1"/>
          <p:nvPr/>
        </p:nvSpPr>
        <p:spPr>
          <a:xfrm>
            <a:off x="3867568" y="6601583"/>
            <a:ext cx="700833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13" dirty="0" err="1"/>
              <a:t>Fosfo</a:t>
            </a:r>
            <a:r>
              <a:rPr lang="es-ES" sz="1013" dirty="0"/>
              <a:t> P38</a:t>
            </a:r>
          </a:p>
        </p:txBody>
      </p:sp>
      <p:pic>
        <p:nvPicPr>
          <p:cNvPr id="114" name="Imagen 113" descr="Diagrama&#10;&#10;Descripción generada automáticamente">
            <a:extLst>
              <a:ext uri="{FF2B5EF4-FFF2-40B4-BE49-F238E27FC236}">
                <a16:creationId xmlns:a16="http://schemas.microsoft.com/office/drawing/2014/main" id="{988EA5B1-B066-B493-0A18-66216AB290A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624" t="8341" r="2311" b="49026"/>
          <a:stretch/>
        </p:blipFill>
        <p:spPr>
          <a:xfrm>
            <a:off x="1844796" y="7926256"/>
            <a:ext cx="1050084" cy="90257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5" name="Rectángulo 114">
            <a:extLst>
              <a:ext uri="{FF2B5EF4-FFF2-40B4-BE49-F238E27FC236}">
                <a16:creationId xmlns:a16="http://schemas.microsoft.com/office/drawing/2014/main" id="{E793D70F-9D4F-DC80-0EF0-00F9547C648D}"/>
              </a:ext>
            </a:extLst>
          </p:cNvPr>
          <p:cNvSpPr/>
          <p:nvPr/>
        </p:nvSpPr>
        <p:spPr>
          <a:xfrm>
            <a:off x="1827815" y="8391500"/>
            <a:ext cx="878140" cy="160945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013"/>
          </a:p>
        </p:txBody>
      </p:sp>
      <p:grpSp>
        <p:nvGrpSpPr>
          <p:cNvPr id="121" name="Grupo 120">
            <a:extLst>
              <a:ext uri="{FF2B5EF4-FFF2-40B4-BE49-F238E27FC236}">
                <a16:creationId xmlns:a16="http://schemas.microsoft.com/office/drawing/2014/main" id="{F7DD65EB-E362-A17D-3E97-08606792C1C6}"/>
              </a:ext>
            </a:extLst>
          </p:cNvPr>
          <p:cNvGrpSpPr/>
          <p:nvPr/>
        </p:nvGrpSpPr>
        <p:grpSpPr>
          <a:xfrm>
            <a:off x="895206" y="8159770"/>
            <a:ext cx="937586" cy="869184"/>
            <a:chOff x="4476963" y="3170363"/>
            <a:chExt cx="794284" cy="838586"/>
          </a:xfrm>
        </p:grpSpPr>
        <p:grpSp>
          <p:nvGrpSpPr>
            <p:cNvPr id="122" name="Grupo 121">
              <a:extLst>
                <a:ext uri="{FF2B5EF4-FFF2-40B4-BE49-F238E27FC236}">
                  <a16:creationId xmlns:a16="http://schemas.microsoft.com/office/drawing/2014/main" id="{1C32FCD2-50E1-2A71-B970-B936B563E03A}"/>
                </a:ext>
              </a:extLst>
            </p:cNvPr>
            <p:cNvGrpSpPr/>
            <p:nvPr/>
          </p:nvGrpSpPr>
          <p:grpSpPr>
            <a:xfrm>
              <a:off x="4999649" y="3302364"/>
              <a:ext cx="271598" cy="495818"/>
              <a:chOff x="4999649" y="3302364"/>
              <a:chExt cx="271598" cy="495818"/>
            </a:xfrm>
          </p:grpSpPr>
          <p:cxnSp>
            <p:nvCxnSpPr>
              <p:cNvPr id="130" name="Conector recto 129">
                <a:extLst>
                  <a:ext uri="{FF2B5EF4-FFF2-40B4-BE49-F238E27FC236}">
                    <a16:creationId xmlns:a16="http://schemas.microsoft.com/office/drawing/2014/main" id="{9BAE5784-6473-4203-3431-4EA9A566E9F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2" y="330236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Conector recto 130">
                <a:extLst>
                  <a:ext uri="{FF2B5EF4-FFF2-40B4-BE49-F238E27FC236}">
                    <a16:creationId xmlns:a16="http://schemas.microsoft.com/office/drawing/2014/main" id="{53B626AC-27CD-74C6-EB4F-7DFCF9E6E03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396889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Conector recto 131">
                <a:extLst>
                  <a:ext uri="{FF2B5EF4-FFF2-40B4-BE49-F238E27FC236}">
                    <a16:creationId xmlns:a16="http://schemas.microsoft.com/office/drawing/2014/main" id="{5426DB23-4980-18AC-742B-8E9B370498D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508365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Conector recto 132">
                <a:extLst>
                  <a:ext uri="{FF2B5EF4-FFF2-40B4-BE49-F238E27FC236}">
                    <a16:creationId xmlns:a16="http://schemas.microsoft.com/office/drawing/2014/main" id="{8020D6D1-2C45-7A34-1EA2-5401F73F3D0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0" y="3626341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34" name="Conector recto 133">
                <a:extLst>
                  <a:ext uri="{FF2B5EF4-FFF2-40B4-BE49-F238E27FC236}">
                    <a16:creationId xmlns:a16="http://schemas.microsoft.com/office/drawing/2014/main" id="{75396E36-C0DE-B193-1BF8-BE5F3487E6E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9" y="3798182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3" name="CuadroTexto 122">
              <a:extLst>
                <a:ext uri="{FF2B5EF4-FFF2-40B4-BE49-F238E27FC236}">
                  <a16:creationId xmlns:a16="http://schemas.microsoft.com/office/drawing/2014/main" id="{4EFDD4F5-A310-5A9D-D0D8-3EB1A1F51018}"/>
                </a:ext>
              </a:extLst>
            </p:cNvPr>
            <p:cNvSpPr txBox="1"/>
            <p:nvPr/>
          </p:nvSpPr>
          <p:spPr>
            <a:xfrm>
              <a:off x="4476963" y="3170363"/>
              <a:ext cx="532607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82kDa</a:t>
              </a:r>
            </a:p>
          </p:txBody>
        </p:sp>
        <p:sp>
          <p:nvSpPr>
            <p:cNvPr id="124" name="CuadroTexto 123">
              <a:extLst>
                <a:ext uri="{FF2B5EF4-FFF2-40B4-BE49-F238E27FC236}">
                  <a16:creationId xmlns:a16="http://schemas.microsoft.com/office/drawing/2014/main" id="{C0CAD623-1A46-A801-44D6-6CF913CB1CE1}"/>
                </a:ext>
              </a:extLst>
            </p:cNvPr>
            <p:cNvSpPr txBox="1"/>
            <p:nvPr/>
          </p:nvSpPr>
          <p:spPr>
            <a:xfrm>
              <a:off x="4476963" y="3254565"/>
              <a:ext cx="532607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16kDa</a:t>
              </a:r>
            </a:p>
          </p:txBody>
        </p:sp>
        <p:sp>
          <p:nvSpPr>
            <p:cNvPr id="125" name="CuadroTexto 124">
              <a:extLst>
                <a:ext uri="{FF2B5EF4-FFF2-40B4-BE49-F238E27FC236}">
                  <a16:creationId xmlns:a16="http://schemas.microsoft.com/office/drawing/2014/main" id="{63692FFD-C2A6-492D-F288-F2585429AF8E}"/>
                </a:ext>
              </a:extLst>
            </p:cNvPr>
            <p:cNvSpPr txBox="1"/>
            <p:nvPr/>
          </p:nvSpPr>
          <p:spPr>
            <a:xfrm>
              <a:off x="4529507" y="3376091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82kDa</a:t>
              </a:r>
            </a:p>
          </p:txBody>
        </p:sp>
        <p:sp>
          <p:nvSpPr>
            <p:cNvPr id="126" name="CuadroTexto 125">
              <a:extLst>
                <a:ext uri="{FF2B5EF4-FFF2-40B4-BE49-F238E27FC236}">
                  <a16:creationId xmlns:a16="http://schemas.microsoft.com/office/drawing/2014/main" id="{EC4458D4-FBD8-6190-6B26-3D00D1D89286}"/>
                </a:ext>
              </a:extLst>
            </p:cNvPr>
            <p:cNvSpPr txBox="1"/>
            <p:nvPr/>
          </p:nvSpPr>
          <p:spPr>
            <a:xfrm>
              <a:off x="4526408" y="3495134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64kDa</a:t>
              </a:r>
            </a:p>
          </p:txBody>
        </p:sp>
        <p:sp>
          <p:nvSpPr>
            <p:cNvPr id="127" name="CuadroTexto 126">
              <a:extLst>
                <a:ext uri="{FF2B5EF4-FFF2-40B4-BE49-F238E27FC236}">
                  <a16:creationId xmlns:a16="http://schemas.microsoft.com/office/drawing/2014/main" id="{961280BA-7786-8C92-D276-A40CC0886686}"/>
                </a:ext>
              </a:extLst>
            </p:cNvPr>
            <p:cNvSpPr txBox="1"/>
            <p:nvPr/>
          </p:nvSpPr>
          <p:spPr>
            <a:xfrm>
              <a:off x="4525817" y="3696136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49kDa</a:t>
              </a:r>
            </a:p>
          </p:txBody>
        </p:sp>
      </p:grpSp>
      <p:sp>
        <p:nvSpPr>
          <p:cNvPr id="137" name="CuadroTexto 136">
            <a:extLst>
              <a:ext uri="{FF2B5EF4-FFF2-40B4-BE49-F238E27FC236}">
                <a16:creationId xmlns:a16="http://schemas.microsoft.com/office/drawing/2014/main" id="{132FFF07-291A-65D4-EBB7-545D316F222E}"/>
              </a:ext>
            </a:extLst>
          </p:cNvPr>
          <p:cNvSpPr txBox="1"/>
          <p:nvPr/>
        </p:nvSpPr>
        <p:spPr>
          <a:xfrm>
            <a:off x="3078583" y="8580623"/>
            <a:ext cx="583814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13" dirty="0" err="1"/>
              <a:t>ZAKalfa</a:t>
            </a:r>
            <a:endParaRPr lang="es-ES" sz="1013" dirty="0"/>
          </a:p>
        </p:txBody>
      </p:sp>
    </p:spTree>
    <p:extLst>
      <p:ext uri="{BB962C8B-B14F-4D97-AF65-F5344CB8AC3E}">
        <p14:creationId xmlns:p14="http://schemas.microsoft.com/office/powerpoint/2010/main" val="23612624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5</TotalTime>
  <Words>46</Words>
  <Application>Microsoft Office PowerPoint</Application>
  <PresentationFormat>Panorámica</PresentationFormat>
  <Paragraphs>4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MANUEL LOZANO GIL</dc:creator>
  <cp:lastModifiedBy>JUAN MANUEL LOZANO GIL</cp:lastModifiedBy>
  <cp:revision>1</cp:revision>
  <dcterms:created xsi:type="dcterms:W3CDTF">2023-07-17T13:35:44Z</dcterms:created>
  <dcterms:modified xsi:type="dcterms:W3CDTF">2023-07-19T13:26:29Z</dcterms:modified>
</cp:coreProperties>
</file>